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85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84.png" ContentType="image/png"/>
  <Override PartName="/ppt/media/image48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18.png" ContentType="image/png"/>
  <Override PartName="/ppt/media/image83.png" ContentType="image/png"/>
  <Override PartName="/ppt/media/image29.png" ContentType="image/png"/>
  <Override PartName="/ppt/media/image94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31.png" ContentType="image/png"/>
  <Override PartName="/ppt/media/image70.png" ContentType="image/png"/>
  <Override PartName="/ppt/media/image69.png" ContentType="image/png"/>
  <Override PartName="/ppt/media/image32.png" ContentType="image/png"/>
  <Override PartName="/ppt/media/image71.png" ContentType="image/png"/>
  <Override PartName="/ppt/media/image61.png" ContentType="image/png"/>
  <Override PartName="/ppt/media/image96.png" ContentType="image/png"/>
  <Override PartName="/ppt/media/image72.png" ContentType="image/png"/>
  <Override PartName="/ppt/media/image23.png" ContentType="image/png"/>
  <Override PartName="/ppt/media/image60.png" ContentType="image/png"/>
  <Override PartName="/ppt/media/image95.png" ContentType="image/png"/>
  <Override PartName="/ppt/media/image89.png" ContentType="image/png"/>
  <Override PartName="/ppt/media/image77.png" ContentType="image/png"/>
  <Override PartName="/ppt/media/image88.png" ContentType="image/png"/>
  <Override PartName="/ppt/media/image76.png" ContentType="image/png"/>
  <Override PartName="/ppt/media/image87.png" ContentType="image/png"/>
  <Override PartName="/ppt/media/image75.png" ContentType="image/png"/>
  <Override PartName="/ppt/media/image79.png" ContentType="image/png"/>
  <Override PartName="/ppt/media/image78.png" ContentType="image/png"/>
  <Override PartName="/ppt/media/image74.png" ContentType="image/png"/>
  <Override PartName="/ppt/media/image73.png" ContentType="image/png"/>
  <Override PartName="/ppt/media/image20.png" ContentType="image/png"/>
  <Override PartName="/ppt/media/image57.png" ContentType="image/png"/>
  <Override PartName="/ppt/media/image24.png" ContentType="image/png"/>
  <Override PartName="/ppt/media/image90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8.png" ContentType="image/png"/>
  <Override PartName="/ppt/media/image93.png" ContentType="image/png"/>
  <Override PartName="/ppt/media/image91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92.png" ContentType="image/png"/>
  <Override PartName="/ppt/media/image27.png" ContentType="image/png"/>
  <Override PartName="/ppt/media/image16.png" ContentType="image/png"/>
  <Override PartName="/ppt/media/image81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82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6C1BA-B4D4-460B-84AF-FE2867379D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87D38-38C3-4CDA-98C9-C7AF866005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E8191-3072-4370-B8ED-77DA68B321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50D48-2350-4394-91A2-E4E9BD6D67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D88E9B-4555-4DC7-B5C3-32584BB131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D40CB-8420-4934-96AC-A25A23DDE3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9F066-4F97-440D-80E6-062611D476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AD23B-A4DB-4C78-AADA-23D356DA26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50338B-1E45-478D-9AF0-E313996DA7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9A02A-6DCD-40C4-B135-1ECBF23B8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3ED631-2138-4927-845F-56427E5ACB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5F06B-CADE-4C69-86B0-BDB7DD97E7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E1613D-6E5A-4F84-8B9A-A3D3955B097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png"/><Relationship Id="rId4" Type="http://schemas.openxmlformats.org/officeDocument/2006/relationships/image" Target="../media/image26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image" Target="../media/image28.png"/><Relationship Id="rId3" Type="http://schemas.openxmlformats.org/officeDocument/2006/relationships/image" Target="../media/image29.png"/><Relationship Id="rId4" Type="http://schemas.openxmlformats.org/officeDocument/2006/relationships/image" Target="../media/image30.png"/><Relationship Id="rId5" Type="http://schemas.openxmlformats.org/officeDocument/2006/relationships/image" Target="../media/image31.png"/><Relationship Id="rId6" Type="http://schemas.openxmlformats.org/officeDocument/2006/relationships/image" Target="../media/image32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38.png"/><Relationship Id="rId8" Type="http://schemas.openxmlformats.org/officeDocument/2006/relationships/image" Target="../media/image39.png"/><Relationship Id="rId9" Type="http://schemas.openxmlformats.org/officeDocument/2006/relationships/image" Target="../media/image40.png"/><Relationship Id="rId10" Type="http://schemas.openxmlformats.org/officeDocument/2006/relationships/image" Target="../media/image41.png"/><Relationship Id="rId11" Type="http://schemas.openxmlformats.org/officeDocument/2006/relationships/image" Target="../media/image42.png"/><Relationship Id="rId12" Type="http://schemas.openxmlformats.org/officeDocument/2006/relationships/image" Target="../media/image43.png"/><Relationship Id="rId13" Type="http://schemas.openxmlformats.org/officeDocument/2006/relationships/image" Target="../media/image44.png"/><Relationship Id="rId14" Type="http://schemas.openxmlformats.org/officeDocument/2006/relationships/image" Target="../media/image45.png"/><Relationship Id="rId15" Type="http://schemas.openxmlformats.org/officeDocument/2006/relationships/image" Target="../media/image46.png"/><Relationship Id="rId16" Type="http://schemas.openxmlformats.org/officeDocument/2006/relationships/image" Target="../media/image47.png"/><Relationship Id="rId17" Type="http://schemas.openxmlformats.org/officeDocument/2006/relationships/image" Target="../media/image48.png"/><Relationship Id="rId18" Type="http://schemas.openxmlformats.org/officeDocument/2006/relationships/image" Target="../media/image7.png"/><Relationship Id="rId19" Type="http://schemas.openxmlformats.org/officeDocument/2006/relationships/image" Target="../media/image2.png"/><Relationship Id="rId20" Type="http://schemas.openxmlformats.org/officeDocument/2006/relationships/image" Target="../media/image3.png"/><Relationship Id="rId21" Type="http://schemas.openxmlformats.org/officeDocument/2006/relationships/image" Target="../media/image7.png"/><Relationship Id="rId22" Type="http://schemas.openxmlformats.org/officeDocument/2006/relationships/image" Target="../media/image2.png"/><Relationship Id="rId23" Type="http://schemas.openxmlformats.org/officeDocument/2006/relationships/image" Target="../media/image3.png"/><Relationship Id="rId24" Type="http://schemas.openxmlformats.org/officeDocument/2006/relationships/image" Target="../media/image49.png"/><Relationship Id="rId25" Type="http://schemas.openxmlformats.org/officeDocument/2006/relationships/image" Target="../media/image50.png"/><Relationship Id="rId26" Type="http://schemas.openxmlformats.org/officeDocument/2006/relationships/image" Target="../media/image51.png"/><Relationship Id="rId27" Type="http://schemas.openxmlformats.org/officeDocument/2006/relationships/image" Target="../media/image52.png"/><Relationship Id="rId28" Type="http://schemas.openxmlformats.org/officeDocument/2006/relationships/image" Target="../media/image53.png"/><Relationship Id="rId29" Type="http://schemas.openxmlformats.org/officeDocument/2006/relationships/image" Target="../media/image54.png"/><Relationship Id="rId30" Type="http://schemas.openxmlformats.org/officeDocument/2006/relationships/image" Target="../media/image55.png"/><Relationship Id="rId31" Type="http://schemas.openxmlformats.org/officeDocument/2006/relationships/image" Target="../media/image56.png"/><Relationship Id="rId32" Type="http://schemas.openxmlformats.org/officeDocument/2006/relationships/image" Target="../media/image57.png"/><Relationship Id="rId33" Type="http://schemas.openxmlformats.org/officeDocument/2006/relationships/image" Target="../media/image58.png"/><Relationship Id="rId34" Type="http://schemas.openxmlformats.org/officeDocument/2006/relationships/image" Target="../media/image59.png"/><Relationship Id="rId35" Type="http://schemas.openxmlformats.org/officeDocument/2006/relationships/image" Target="../media/image60.png"/><Relationship Id="rId36" Type="http://schemas.openxmlformats.org/officeDocument/2006/relationships/image" Target="../media/image61.png"/><Relationship Id="rId37" Type="http://schemas.openxmlformats.org/officeDocument/2006/relationships/image" Target="../media/image62.png"/><Relationship Id="rId38" Type="http://schemas.openxmlformats.org/officeDocument/2006/relationships/image" Target="../media/image63.png"/><Relationship Id="rId39" Type="http://schemas.openxmlformats.org/officeDocument/2006/relationships/image" Target="../media/image64.png"/><Relationship Id="rId40" Type="http://schemas.openxmlformats.org/officeDocument/2006/relationships/image" Target="../media/image65.png"/><Relationship Id="rId41" Type="http://schemas.openxmlformats.org/officeDocument/2006/relationships/image" Target="../media/image66.png"/><Relationship Id="rId42" Type="http://schemas.openxmlformats.org/officeDocument/2006/relationships/image" Target="../media/image67.png"/><Relationship Id="rId43" Type="http://schemas.openxmlformats.org/officeDocument/2006/relationships/image" Target="../media/image68.png"/><Relationship Id="rId44" Type="http://schemas.openxmlformats.org/officeDocument/2006/relationships/image" Target="../media/image69.png"/><Relationship Id="rId45" Type="http://schemas.openxmlformats.org/officeDocument/2006/relationships/image" Target="../media/image70.png"/><Relationship Id="rId46" Type="http://schemas.openxmlformats.org/officeDocument/2006/relationships/image" Target="../media/image71.png"/><Relationship Id="rId47" Type="http://schemas.openxmlformats.org/officeDocument/2006/relationships/image" Target="../media/image72.png"/><Relationship Id="rId48" Type="http://schemas.openxmlformats.org/officeDocument/2006/relationships/image" Target="../media/image73.png"/><Relationship Id="rId49" Type="http://schemas.openxmlformats.org/officeDocument/2006/relationships/image" Target="../media/image74.png"/><Relationship Id="rId50" Type="http://schemas.openxmlformats.org/officeDocument/2006/relationships/image" Target="../media/image75.png"/><Relationship Id="rId51" Type="http://schemas.openxmlformats.org/officeDocument/2006/relationships/image" Target="../media/image76.png"/><Relationship Id="rId52" Type="http://schemas.openxmlformats.org/officeDocument/2006/relationships/image" Target="../media/image77.png"/><Relationship Id="rId53" Type="http://schemas.openxmlformats.org/officeDocument/2006/relationships/image" Target="../media/image78.png"/><Relationship Id="rId54" Type="http://schemas.openxmlformats.org/officeDocument/2006/relationships/image" Target="../media/image79.png"/><Relationship Id="rId55" Type="http://schemas.openxmlformats.org/officeDocument/2006/relationships/image" Target="../media/image80.png"/><Relationship Id="rId56" Type="http://schemas.openxmlformats.org/officeDocument/2006/relationships/image" Target="../media/image23.png"/><Relationship Id="rId57" Type="http://schemas.openxmlformats.org/officeDocument/2006/relationships/image" Target="../media/image81.png"/><Relationship Id="rId58" Type="http://schemas.openxmlformats.org/officeDocument/2006/relationships/image" Target="../media/image82.png"/><Relationship Id="rId59" Type="http://schemas.openxmlformats.org/officeDocument/2006/relationships/image" Target="../media/image83.png"/><Relationship Id="rId60" Type="http://schemas.openxmlformats.org/officeDocument/2006/relationships/image" Target="../media/image84.png"/><Relationship Id="rId61" Type="http://schemas.openxmlformats.org/officeDocument/2006/relationships/image" Target="../media/image85.png"/><Relationship Id="rId62" Type="http://schemas.openxmlformats.org/officeDocument/2006/relationships/image" Target="../media/image86.png"/><Relationship Id="rId63" Type="http://schemas.openxmlformats.org/officeDocument/2006/relationships/image" Target="../media/image87.png"/><Relationship Id="rId64" Type="http://schemas.openxmlformats.org/officeDocument/2006/relationships/image" Target="../media/image88.png"/><Relationship Id="rId65" Type="http://schemas.openxmlformats.org/officeDocument/2006/relationships/image" Target="../media/image89.png"/><Relationship Id="rId66" Type="http://schemas.openxmlformats.org/officeDocument/2006/relationships/image" Target="../media/image90.png"/><Relationship Id="rId67" Type="http://schemas.openxmlformats.org/officeDocument/2006/relationships/image" Target="../media/image91.png"/><Relationship Id="rId68" Type="http://schemas.openxmlformats.org/officeDocument/2006/relationships/image" Target="../media/image92.png"/><Relationship Id="rId69" Type="http://schemas.openxmlformats.org/officeDocument/2006/relationships/image" Target="../media/image93.png"/><Relationship Id="rId70" Type="http://schemas.openxmlformats.org/officeDocument/2006/relationships/image" Target="../media/image2.png"/><Relationship Id="rId71" Type="http://schemas.openxmlformats.org/officeDocument/2006/relationships/image" Target="../media/image3.png"/><Relationship Id="rId72" Type="http://schemas.openxmlformats.org/officeDocument/2006/relationships/image" Target="../media/image4.png"/><Relationship Id="rId73" Type="http://schemas.openxmlformats.org/officeDocument/2006/relationships/image" Target="../media/image5.png"/><Relationship Id="rId74" Type="http://schemas.openxmlformats.org/officeDocument/2006/relationships/image" Target="../media/image6.png"/><Relationship Id="rId75" Type="http://schemas.openxmlformats.org/officeDocument/2006/relationships/image" Target="../media/image7.png"/><Relationship Id="rId76" Type="http://schemas.openxmlformats.org/officeDocument/2006/relationships/image" Target="../media/image8.png"/><Relationship Id="rId77" Type="http://schemas.openxmlformats.org/officeDocument/2006/relationships/image" Target="../media/image9.png"/><Relationship Id="rId78" Type="http://schemas.openxmlformats.org/officeDocument/2006/relationships/image" Target="../media/image10.png"/><Relationship Id="rId79" Type="http://schemas.openxmlformats.org/officeDocument/2006/relationships/image" Target="../media/image11.png"/><Relationship Id="rId80" Type="http://schemas.openxmlformats.org/officeDocument/2006/relationships/image" Target="../media/image12.png"/><Relationship Id="rId81" Type="http://schemas.openxmlformats.org/officeDocument/2006/relationships/image" Target="../media/image13.png"/><Relationship Id="rId82" Type="http://schemas.openxmlformats.org/officeDocument/2006/relationships/image" Target="../media/image14.png"/><Relationship Id="rId83" Type="http://schemas.openxmlformats.org/officeDocument/2006/relationships/image" Target="../media/image15.png"/><Relationship Id="rId84" Type="http://schemas.openxmlformats.org/officeDocument/2006/relationships/image" Target="../media/image16.png"/><Relationship Id="rId85" Type="http://schemas.openxmlformats.org/officeDocument/2006/relationships/image" Target="../media/image17.png"/><Relationship Id="rId86" Type="http://schemas.openxmlformats.org/officeDocument/2006/relationships/image" Target="../media/image18.png"/><Relationship Id="rId87" Type="http://schemas.openxmlformats.org/officeDocument/2006/relationships/image" Target="../media/image19.png"/><Relationship Id="rId88" Type="http://schemas.openxmlformats.org/officeDocument/2006/relationships/image" Target="../media/image20.png"/><Relationship Id="rId89" Type="http://schemas.openxmlformats.org/officeDocument/2006/relationships/image" Target="../media/image21.png"/><Relationship Id="rId90" Type="http://schemas.openxmlformats.org/officeDocument/2006/relationships/image" Target="../media/image22.png"/><Relationship Id="rId9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4.png"/><Relationship Id="rId2" Type="http://schemas.openxmlformats.org/officeDocument/2006/relationships/image" Target="../media/image95.png"/><Relationship Id="rId3" Type="http://schemas.openxmlformats.org/officeDocument/2006/relationships/image" Target="../media/image96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289800" y="330120"/>
            <a:ext cx="8486280" cy="6282000"/>
            <a:chOff x="289800" y="330120"/>
            <a:chExt cx="8486280" cy="6282000"/>
          </a:xfrm>
        </p:grpSpPr>
        <p:grpSp>
          <p:nvGrpSpPr>
            <p:cNvPr id="42" name="Group 2"/>
            <p:cNvGrpSpPr/>
            <p:nvPr/>
          </p:nvGrpSpPr>
          <p:grpSpPr>
            <a:xfrm>
              <a:off x="2233080" y="1778040"/>
              <a:ext cx="4419720" cy="1732680"/>
              <a:chOff x="2233080" y="1778040"/>
              <a:chExt cx="4419720" cy="1732680"/>
            </a:xfrm>
          </p:grpSpPr>
          <p:grpSp>
            <p:nvGrpSpPr>
              <p:cNvPr id="43" name="Group 15"/>
              <p:cNvGrpSpPr/>
              <p:nvPr/>
            </p:nvGrpSpPr>
            <p:grpSpPr>
              <a:xfrm>
                <a:off x="5052600" y="1778040"/>
                <a:ext cx="1600200" cy="1732680"/>
                <a:chOff x="5052600" y="1778040"/>
                <a:chExt cx="1600200" cy="1732680"/>
              </a:xfrm>
            </p:grpSpPr>
            <p:grpSp>
              <p:nvGrpSpPr>
                <p:cNvPr id="44" name="Group 16"/>
                <p:cNvGrpSpPr/>
                <p:nvPr/>
              </p:nvGrpSpPr>
              <p:grpSpPr>
                <a:xfrm>
                  <a:off x="5334840" y="1778040"/>
                  <a:ext cx="1005480" cy="1308960"/>
                  <a:chOff x="5334840" y="1778040"/>
                  <a:chExt cx="1005480" cy="1308960"/>
                </a:xfrm>
              </p:grpSpPr>
              <p:sp>
                <p:nvSpPr>
                  <p:cNvPr id="45" name="Freeform 20"/>
                  <p:cNvSpPr/>
                  <p:nvPr/>
                </p:nvSpPr>
                <p:spPr>
                  <a:xfrm>
                    <a:off x="5334840" y="1878120"/>
                    <a:ext cx="478080" cy="1208880"/>
                  </a:xfrm>
                  <a:custGeom>
                    <a:avLst/>
                    <a:gdLst/>
                    <a:ahLst/>
                    <a:rect l="l" t="t" r="r" b="b"/>
                    <a:pathLst>
                      <a:path w="409433" h="1009934">
                        <a:moveTo>
                          <a:pt x="409433" y="1009934"/>
                        </a:moveTo>
                        <a:cubicBezTo>
                          <a:pt x="370764" y="922361"/>
                          <a:pt x="332096" y="834788"/>
                          <a:pt x="327547" y="750627"/>
                        </a:cubicBezTo>
                        <a:cubicBezTo>
                          <a:pt x="322998" y="666466"/>
                          <a:pt x="382138" y="586853"/>
                          <a:pt x="382138" y="504967"/>
                        </a:cubicBezTo>
                        <a:cubicBezTo>
                          <a:pt x="382138" y="423081"/>
                          <a:pt x="357117" y="327547"/>
                          <a:pt x="327547" y="259308"/>
                        </a:cubicBezTo>
                        <a:cubicBezTo>
                          <a:pt x="297977" y="191069"/>
                          <a:pt x="259308" y="138752"/>
                          <a:pt x="204717" y="95534"/>
                        </a:cubicBezTo>
                        <a:cubicBezTo>
                          <a:pt x="150126" y="52316"/>
                          <a:pt x="75063" y="26158"/>
                          <a:pt x="0" y="0"/>
                        </a:cubicBezTo>
                      </a:path>
                    </a:pathLst>
                  </a:custGeom>
                  <a:noFill/>
                  <a:ln w="25560">
                    <a:solidFill>
                      <a:srgbClr val="ff0000"/>
                    </a:solidFill>
                    <a:round/>
                    <a:head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" name="Freeform 21"/>
                  <p:cNvSpPr/>
                  <p:nvPr/>
                </p:nvSpPr>
                <p:spPr>
                  <a:xfrm>
                    <a:off x="5733360" y="1778040"/>
                    <a:ext cx="168120" cy="900720"/>
                  </a:xfrm>
                  <a:custGeom>
                    <a:avLst/>
                    <a:gdLst/>
                    <a:ahLst/>
                    <a:rect l="l" t="t" r="r" b="b"/>
                    <a:pathLst>
                      <a:path w="143405" h="751800">
                        <a:moveTo>
                          <a:pt x="0" y="751800"/>
                        </a:moveTo>
                        <a:cubicBezTo>
                          <a:pt x="36394" y="674462"/>
                          <a:pt x="72789" y="597125"/>
                          <a:pt x="95535" y="533436"/>
                        </a:cubicBezTo>
                        <a:cubicBezTo>
                          <a:pt x="118281" y="469747"/>
                          <a:pt x="129654" y="426529"/>
                          <a:pt x="136478" y="369663"/>
                        </a:cubicBezTo>
                        <a:cubicBezTo>
                          <a:pt x="143302" y="312797"/>
                          <a:pt x="147851" y="249108"/>
                          <a:pt x="136478" y="192242"/>
                        </a:cubicBezTo>
                        <a:cubicBezTo>
                          <a:pt x="125105" y="135376"/>
                          <a:pt x="81887" y="60313"/>
                          <a:pt x="68239" y="28469"/>
                        </a:cubicBezTo>
                        <a:cubicBezTo>
                          <a:pt x="54591" y="-3375"/>
                          <a:pt x="54591" y="-1101"/>
                          <a:pt x="54591" y="1174"/>
                        </a:cubicBezTo>
                      </a:path>
                    </a:pathLst>
                  </a:custGeom>
                  <a:noFill/>
                  <a:ln w="25560">
                    <a:solidFill>
                      <a:srgbClr val="ff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" name="Freeform 22"/>
                  <p:cNvSpPr/>
                  <p:nvPr/>
                </p:nvSpPr>
                <p:spPr>
                  <a:xfrm>
                    <a:off x="5862240" y="1959120"/>
                    <a:ext cx="478080" cy="425520"/>
                  </a:xfrm>
                  <a:custGeom>
                    <a:avLst/>
                    <a:gdLst/>
                    <a:ahLst/>
                    <a:rect l="l" t="t" r="r" b="b"/>
                    <a:pathLst>
                      <a:path w="409433" h="354842">
                        <a:moveTo>
                          <a:pt x="0" y="354842"/>
                        </a:moveTo>
                        <a:cubicBezTo>
                          <a:pt x="34120" y="310486"/>
                          <a:pt x="68240" y="266131"/>
                          <a:pt x="109183" y="218364"/>
                        </a:cubicBezTo>
                        <a:cubicBezTo>
                          <a:pt x="150126" y="170597"/>
                          <a:pt x="209266" y="100084"/>
                          <a:pt x="245660" y="68239"/>
                        </a:cubicBezTo>
                        <a:cubicBezTo>
                          <a:pt x="282054" y="36394"/>
                          <a:pt x="300252" y="38668"/>
                          <a:pt x="327547" y="27295"/>
                        </a:cubicBezTo>
                        <a:cubicBezTo>
                          <a:pt x="354842" y="15922"/>
                          <a:pt x="382137" y="7961"/>
                          <a:pt x="409433" y="0"/>
                        </a:cubicBezTo>
                      </a:path>
                    </a:pathLst>
                  </a:custGeom>
                  <a:noFill/>
                  <a:ln w="25560">
                    <a:solidFill>
                      <a:srgbClr val="ff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8" name="TextBox 22"/>
                <p:cNvSpPr/>
                <p:nvPr/>
              </p:nvSpPr>
              <p:spPr>
                <a:xfrm>
                  <a:off x="5052600" y="3142440"/>
                  <a:ext cx="1600200" cy="3682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Many-to-one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" name="Group 14"/>
              <p:cNvGrpSpPr/>
              <p:nvPr/>
            </p:nvGrpSpPr>
            <p:grpSpPr>
              <a:xfrm>
                <a:off x="2233080" y="1778040"/>
                <a:ext cx="1641600" cy="1732680"/>
                <a:chOff x="2233080" y="1778040"/>
                <a:chExt cx="1641600" cy="1732680"/>
              </a:xfrm>
            </p:grpSpPr>
            <p:grpSp>
              <p:nvGrpSpPr>
                <p:cNvPr id="50" name="Group 12"/>
                <p:cNvGrpSpPr/>
                <p:nvPr/>
              </p:nvGrpSpPr>
              <p:grpSpPr>
                <a:xfrm>
                  <a:off x="2426040" y="1778040"/>
                  <a:ext cx="1007280" cy="1326960"/>
                  <a:chOff x="2426040" y="1778040"/>
                  <a:chExt cx="1007280" cy="1326960"/>
                </a:xfrm>
              </p:grpSpPr>
              <p:sp>
                <p:nvSpPr>
                  <p:cNvPr id="51" name="Freeform 15"/>
                  <p:cNvSpPr/>
                  <p:nvPr/>
                </p:nvSpPr>
                <p:spPr>
                  <a:xfrm>
                    <a:off x="2426040" y="1879560"/>
                    <a:ext cx="479880" cy="1225440"/>
                  </a:xfrm>
                  <a:custGeom>
                    <a:avLst/>
                    <a:gdLst/>
                    <a:ahLst/>
                    <a:rect l="l" t="t" r="r" b="b"/>
                    <a:pathLst>
                      <a:path w="409433" h="1009934">
                        <a:moveTo>
                          <a:pt x="409433" y="1009934"/>
                        </a:moveTo>
                        <a:cubicBezTo>
                          <a:pt x="370764" y="922361"/>
                          <a:pt x="332096" y="834788"/>
                          <a:pt x="327547" y="750627"/>
                        </a:cubicBezTo>
                        <a:cubicBezTo>
                          <a:pt x="322998" y="666466"/>
                          <a:pt x="382138" y="586853"/>
                          <a:pt x="382138" y="504967"/>
                        </a:cubicBezTo>
                        <a:cubicBezTo>
                          <a:pt x="382138" y="423081"/>
                          <a:pt x="357117" y="327547"/>
                          <a:pt x="327547" y="259308"/>
                        </a:cubicBezTo>
                        <a:cubicBezTo>
                          <a:pt x="297977" y="191069"/>
                          <a:pt x="259308" y="138752"/>
                          <a:pt x="204717" y="95534"/>
                        </a:cubicBezTo>
                        <a:cubicBezTo>
                          <a:pt x="150126" y="52316"/>
                          <a:pt x="75063" y="26158"/>
                          <a:pt x="0" y="0"/>
                        </a:cubicBezTo>
                      </a:path>
                    </a:pathLst>
                  </a:custGeom>
                  <a:noFill/>
                  <a:ln w="25560">
                    <a:solidFill>
                      <a:srgbClr val="184ad8"/>
                    </a:solidFill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Freeform 16"/>
                  <p:cNvSpPr/>
                  <p:nvPr/>
                </p:nvSpPr>
                <p:spPr>
                  <a:xfrm>
                    <a:off x="2826360" y="1778040"/>
                    <a:ext cx="166680" cy="912600"/>
                  </a:xfrm>
                  <a:custGeom>
                    <a:avLst/>
                    <a:gdLst/>
                    <a:ahLst/>
                    <a:rect l="l" t="t" r="r" b="b"/>
                    <a:pathLst>
                      <a:path w="143405" h="751800">
                        <a:moveTo>
                          <a:pt x="0" y="751800"/>
                        </a:moveTo>
                        <a:cubicBezTo>
                          <a:pt x="36394" y="674462"/>
                          <a:pt x="72789" y="597125"/>
                          <a:pt x="95535" y="533436"/>
                        </a:cubicBezTo>
                        <a:cubicBezTo>
                          <a:pt x="118281" y="469747"/>
                          <a:pt x="129654" y="426529"/>
                          <a:pt x="136478" y="369663"/>
                        </a:cubicBezTo>
                        <a:cubicBezTo>
                          <a:pt x="143302" y="312797"/>
                          <a:pt x="147851" y="249108"/>
                          <a:pt x="136478" y="192242"/>
                        </a:cubicBezTo>
                        <a:cubicBezTo>
                          <a:pt x="125105" y="135376"/>
                          <a:pt x="81887" y="60313"/>
                          <a:pt x="68239" y="28469"/>
                        </a:cubicBezTo>
                        <a:cubicBezTo>
                          <a:pt x="54591" y="-3375"/>
                          <a:pt x="54591" y="-1101"/>
                          <a:pt x="54591" y="1174"/>
                        </a:cubicBezTo>
                      </a:path>
                    </a:pathLst>
                  </a:custGeom>
                  <a:noFill/>
                  <a:ln w="25560">
                    <a:solidFill>
                      <a:srgbClr val="184ad8"/>
                    </a:solidFill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Freeform 17"/>
                  <p:cNvSpPr/>
                  <p:nvPr/>
                </p:nvSpPr>
                <p:spPr>
                  <a:xfrm>
                    <a:off x="2953440" y="1962000"/>
                    <a:ext cx="479880" cy="430200"/>
                  </a:xfrm>
                  <a:custGeom>
                    <a:avLst/>
                    <a:gdLst/>
                    <a:ahLst/>
                    <a:rect l="l" t="t" r="r" b="b"/>
                    <a:pathLst>
                      <a:path w="409433" h="354842">
                        <a:moveTo>
                          <a:pt x="0" y="354842"/>
                        </a:moveTo>
                        <a:cubicBezTo>
                          <a:pt x="34120" y="310486"/>
                          <a:pt x="68240" y="266131"/>
                          <a:pt x="109183" y="218364"/>
                        </a:cubicBezTo>
                        <a:cubicBezTo>
                          <a:pt x="150126" y="170597"/>
                          <a:pt x="209266" y="100084"/>
                          <a:pt x="245660" y="68239"/>
                        </a:cubicBezTo>
                        <a:cubicBezTo>
                          <a:pt x="282054" y="36394"/>
                          <a:pt x="300252" y="38668"/>
                          <a:pt x="327547" y="27295"/>
                        </a:cubicBezTo>
                        <a:cubicBezTo>
                          <a:pt x="354842" y="15922"/>
                          <a:pt x="382137" y="7961"/>
                          <a:pt x="409433" y="0"/>
                        </a:cubicBezTo>
                      </a:path>
                    </a:pathLst>
                  </a:custGeom>
                  <a:noFill/>
                  <a:ln w="25560">
                    <a:solidFill>
                      <a:srgbClr val="184ad8"/>
                    </a:solidFill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4" name="TextBox 23"/>
                <p:cNvSpPr/>
                <p:nvPr/>
              </p:nvSpPr>
              <p:spPr>
                <a:xfrm>
                  <a:off x="2233080" y="3142440"/>
                  <a:ext cx="1641600" cy="3682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800" spc="-1" strike="noStrike">
                      <a:solidFill>
                        <a:srgbClr val="000000"/>
                      </a:solidFill>
                      <a:latin typeface="Arial"/>
                    </a:rPr>
                    <a:t>One-to-many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55" name="TextBox 4"/>
            <p:cNvSpPr/>
            <p:nvPr/>
          </p:nvSpPr>
          <p:spPr>
            <a:xfrm>
              <a:off x="1166040" y="330120"/>
              <a:ext cx="6019920" cy="173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6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US" sz="3600" spc="-1" strike="noStrike">
                  <a:solidFill>
                    <a:srgbClr val="000000"/>
                  </a:solidFill>
                  <a:latin typeface="Arial"/>
                </a:rPr>
                <a:t>The construct: </a:t>
              </a: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000000"/>
                  </a:solidFill>
                  <a:latin typeface="Arial"/>
                </a:rPr>
                <a:t>complex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and </a:t>
              </a:r>
              <a:r>
                <a:rPr b="1" i="1" lang="en-US" sz="1800" spc="-1" strike="noStrike">
                  <a:solidFill>
                    <a:srgbClr val="000000"/>
                  </a:solidFill>
                  <a:latin typeface="Arial"/>
                </a:rPr>
                <a:t>dynamic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indicators are designed to capture both ‘one-to-many’ and ‘many-to-one’ relationships.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"/>
            <p:cNvSpPr/>
            <p:nvPr/>
          </p:nvSpPr>
          <p:spPr>
            <a:xfrm>
              <a:off x="584640" y="3759480"/>
              <a:ext cx="7470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Example of a complex indicator: [M/L * N/M] / [N/L * L/M] over [M+L/N] / [N+M]/L * [M/N]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"/>
            <p:cNvSpPr/>
            <p:nvPr/>
          </p:nvSpPr>
          <p:spPr>
            <a:xfrm>
              <a:off x="1541880" y="4216680"/>
              <a:ext cx="553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How many interactions are measured by just one indicator?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"/>
            <p:cNvSpPr/>
            <p:nvPr/>
          </p:nvSpPr>
          <p:spPr>
            <a:xfrm>
              <a:off x="289800" y="4597920"/>
              <a:ext cx="8486280" cy="20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The numerator measures all 3 simple ratios  --those involving 2 cell types (M/L, N/M,  N/L , an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the inverse of  M/L: the L/M ratio). In addition, the numerator calculates 2 products, which involve 2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ratios, each. Furthermore, the numerator calculates a complex ratio (the division of [ML * N/M] over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[N/L*L/M]). Hence, the numerator captures 16 relationships :4 (simple ratios) x 2 (products) x 2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(complex ratios). While the denominator also measures 16 relationships, they are different: they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include 3 cell types. This indicator measures </a:t>
              </a:r>
              <a:r>
                <a:rPr b="1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at least 32 relationships, which include 2- and 3-cel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interactions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  <a:ea typeface="SimSun"/>
                </a:rPr>
                <a:t>. Thus, the number of combinations a 3D plot can measure approaches infinity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Rectangle 23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4"/>
          <p:cNvGrpSpPr/>
          <p:nvPr/>
        </p:nvGrpSpPr>
        <p:grpSpPr>
          <a:xfrm>
            <a:off x="-152280" y="579600"/>
            <a:ext cx="8991360" cy="4674960"/>
            <a:chOff x="-152280" y="579600"/>
            <a:chExt cx="8991360" cy="4674960"/>
          </a:xfrm>
        </p:grpSpPr>
        <p:pic>
          <p:nvPicPr>
            <p:cNvPr id="61" name="Picture 5" descr=""/>
            <p:cNvPicPr/>
            <p:nvPr/>
          </p:nvPicPr>
          <p:blipFill>
            <a:blip r:embed="rId1"/>
            <a:stretch/>
          </p:blipFill>
          <p:spPr>
            <a:xfrm>
              <a:off x="-152280" y="2590920"/>
              <a:ext cx="2666880" cy="1778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2" name="Group 10241"/>
            <p:cNvGrpSpPr/>
            <p:nvPr/>
          </p:nvGrpSpPr>
          <p:grpSpPr>
            <a:xfrm>
              <a:off x="3505320" y="992160"/>
              <a:ext cx="5089320" cy="1598400"/>
              <a:chOff x="3505320" y="992160"/>
              <a:chExt cx="5089320" cy="1598400"/>
            </a:xfrm>
          </p:grpSpPr>
          <p:grpSp>
            <p:nvGrpSpPr>
              <p:cNvPr id="63" name="Group 126"/>
              <p:cNvGrpSpPr/>
              <p:nvPr/>
            </p:nvGrpSpPr>
            <p:grpSpPr>
              <a:xfrm>
                <a:off x="4187880" y="992160"/>
                <a:ext cx="2435040" cy="368280"/>
                <a:chOff x="4187880" y="992160"/>
                <a:chExt cx="2435040" cy="368280"/>
              </a:xfrm>
            </p:grpSpPr>
            <p:sp>
              <p:nvSpPr>
                <p:cNvPr id="64" name="Freeform 54"/>
                <p:cNvSpPr/>
                <p:nvPr/>
              </p:nvSpPr>
              <p:spPr>
                <a:xfrm>
                  <a:off x="4270320" y="1098360"/>
                  <a:ext cx="1800000" cy="262080"/>
                </a:xfrm>
                <a:custGeom>
                  <a:avLst/>
                  <a:gdLst/>
                  <a:ahLst/>
                  <a:rect l="l" t="t" r="r" b="b"/>
                  <a:pathLst>
                    <a:path w="1356479" h="261491">
                      <a:moveTo>
                        <a:pt x="0" y="261491"/>
                      </a:moveTo>
                      <a:cubicBezTo>
                        <a:pt x="400579" y="139253"/>
                        <a:pt x="801158" y="17016"/>
                        <a:pt x="1022350" y="1141"/>
                      </a:cubicBezTo>
                      <a:cubicBezTo>
                        <a:pt x="1243542" y="-14734"/>
                        <a:pt x="1276350" y="139783"/>
                        <a:pt x="1327150" y="166241"/>
                      </a:cubicBezTo>
                      <a:cubicBezTo>
                        <a:pt x="1377950" y="192699"/>
                        <a:pt x="1352550" y="176295"/>
                        <a:pt x="1327150" y="159891"/>
                      </a:cubicBez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Freeform 55"/>
                <p:cNvSpPr/>
                <p:nvPr/>
              </p:nvSpPr>
              <p:spPr>
                <a:xfrm>
                  <a:off x="4187880" y="992160"/>
                  <a:ext cx="2435040" cy="343080"/>
                </a:xfrm>
                <a:custGeom>
                  <a:avLst/>
                  <a:gdLst/>
                  <a:ahLst/>
                  <a:rect l="l" t="t" r="r" b="b"/>
                  <a:pathLst>
                    <a:path w="1847850" h="343125">
                      <a:moveTo>
                        <a:pt x="0" y="343125"/>
                      </a:moveTo>
                      <a:cubicBezTo>
                        <a:pt x="455612" y="176437"/>
                        <a:pt x="911225" y="9750"/>
                        <a:pt x="1219200" y="225"/>
                      </a:cubicBezTo>
                      <a:cubicBezTo>
                        <a:pt x="1527175" y="-9300"/>
                        <a:pt x="1847850" y="285975"/>
                        <a:pt x="1847850" y="285975"/>
                      </a:cubicBezTo>
                      <a:lnTo>
                        <a:pt x="1847850" y="285975"/>
                      </a:ln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6" name="Group 99"/>
              <p:cNvGrpSpPr/>
              <p:nvPr/>
            </p:nvGrpSpPr>
            <p:grpSpPr>
              <a:xfrm>
                <a:off x="7118280" y="1062000"/>
                <a:ext cx="1476360" cy="1522440"/>
                <a:chOff x="7118280" y="1062000"/>
                <a:chExt cx="1476360" cy="1522440"/>
              </a:xfrm>
            </p:grpSpPr>
            <p:grpSp>
              <p:nvGrpSpPr>
                <p:cNvPr id="67" name="Group 127"/>
                <p:cNvGrpSpPr/>
                <p:nvPr/>
              </p:nvGrpSpPr>
              <p:grpSpPr>
                <a:xfrm>
                  <a:off x="7118280" y="1062000"/>
                  <a:ext cx="890640" cy="416160"/>
                  <a:chOff x="7118280" y="1062000"/>
                  <a:chExt cx="890640" cy="416160"/>
                </a:xfrm>
              </p:grpSpPr>
              <p:sp>
                <p:nvSpPr>
                  <p:cNvPr id="68" name="Freeform 52"/>
                  <p:cNvSpPr/>
                  <p:nvPr/>
                </p:nvSpPr>
                <p:spPr>
                  <a:xfrm>
                    <a:off x="7118280" y="1093680"/>
                    <a:ext cx="341280" cy="370080"/>
                  </a:xfrm>
                  <a:custGeom>
                    <a:avLst/>
                    <a:gdLst/>
                    <a:ahLst/>
                    <a:rect l="l" t="t" r="r" b="b"/>
                    <a:pathLst>
                      <a:path w="341906" h="370313">
                        <a:moveTo>
                          <a:pt x="0" y="370313"/>
                        </a:moveTo>
                        <a:cubicBezTo>
                          <a:pt x="31143" y="205323"/>
                          <a:pt x="62286" y="40334"/>
                          <a:pt x="119270" y="4553"/>
                        </a:cubicBezTo>
                        <a:cubicBezTo>
                          <a:pt x="176254" y="-31228"/>
                          <a:pt x="341906" y="155628"/>
                          <a:pt x="341906" y="155628"/>
                        </a:cubicBezTo>
                        <a:lnTo>
                          <a:pt x="341906" y="155628"/>
                        </a:lnTo>
                      </a:path>
                    </a:pathLst>
                  </a:custGeom>
                  <a:noFill/>
                  <a:ln w="3240">
                    <a:solidFill>
                      <a:srgbClr val="00b050"/>
                    </a:solidFill>
                    <a:prstDash val="dash"/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Freeform 53"/>
                  <p:cNvSpPr/>
                  <p:nvPr/>
                </p:nvSpPr>
                <p:spPr>
                  <a:xfrm>
                    <a:off x="7148160" y="1062000"/>
                    <a:ext cx="860760" cy="416160"/>
                  </a:xfrm>
                  <a:custGeom>
                    <a:avLst/>
                    <a:gdLst/>
                    <a:ahLst/>
                    <a:rect l="l" t="t" r="r" b="b"/>
                    <a:pathLst>
                      <a:path w="341906" h="370313">
                        <a:moveTo>
                          <a:pt x="0" y="370313"/>
                        </a:moveTo>
                        <a:cubicBezTo>
                          <a:pt x="31143" y="205323"/>
                          <a:pt x="62286" y="40334"/>
                          <a:pt x="119270" y="4553"/>
                        </a:cubicBezTo>
                        <a:cubicBezTo>
                          <a:pt x="176254" y="-31228"/>
                          <a:pt x="341906" y="155628"/>
                          <a:pt x="341906" y="155628"/>
                        </a:cubicBezTo>
                        <a:lnTo>
                          <a:pt x="341906" y="155628"/>
                        </a:lnTo>
                      </a:path>
                    </a:pathLst>
                  </a:custGeom>
                  <a:noFill/>
                  <a:ln w="3240">
                    <a:solidFill>
                      <a:srgbClr val="ff0000"/>
                    </a:solidFill>
                    <a:prstDash val="sysDash"/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pic>
              <p:nvPicPr>
                <p:cNvPr id="70" name="Picture 16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8012160" y="1808640"/>
                  <a:ext cx="582480" cy="389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1" name="Picture 17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8016840" y="2203560"/>
                  <a:ext cx="571320" cy="380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2" name="Picture 79913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7305480" y="1810080"/>
                  <a:ext cx="561240" cy="374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3" name="Picture 79914" descr="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7308720" y="2201400"/>
                  <a:ext cx="558720" cy="372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4" name="Picture 79872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7313400" y="1425960"/>
                  <a:ext cx="554040" cy="367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5" name="Picture 15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8012160" y="1425240"/>
                  <a:ext cx="568440" cy="3780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76" name="Group 97"/>
              <p:cNvGrpSpPr/>
              <p:nvPr/>
            </p:nvGrpSpPr>
            <p:grpSpPr>
              <a:xfrm>
                <a:off x="5708520" y="1355400"/>
                <a:ext cx="1342800" cy="1235160"/>
                <a:chOff x="5708520" y="1355400"/>
                <a:chExt cx="1342800" cy="1235160"/>
              </a:xfrm>
            </p:grpSpPr>
            <p:pic>
              <p:nvPicPr>
                <p:cNvPr id="77" name="Picture 10" descr="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5708520" y="1355400"/>
                  <a:ext cx="648000" cy="433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78" name="Picture 97" descr="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5718240" y="1761120"/>
                  <a:ext cx="637920" cy="426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9" name="Straight Connector 40"/>
                <p:cNvSpPr/>
                <p:nvPr/>
              </p:nvSpPr>
              <p:spPr>
                <a:xfrm>
                  <a:off x="6554520" y="2520720"/>
                  <a:ext cx="291960" cy="0"/>
                </a:xfrm>
                <a:prstGeom prst="line">
                  <a:avLst/>
                </a:prstGeom>
                <a:ln w="9360">
                  <a:solidFill>
                    <a:srgbClr val="00b05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80" name="Picture 96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5709960" y="2149200"/>
                  <a:ext cx="645480" cy="431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1" name="Picture 101" descr="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6379920" y="1374480"/>
                  <a:ext cx="667080" cy="444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2" name="Picture 102" descr="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6387120" y="1764720"/>
                  <a:ext cx="664200" cy="4428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3" name="Picture 103" descr=""/>
                <p:cNvPicPr/>
                <p:nvPr/>
              </p:nvPicPr>
              <p:blipFill>
                <a:blip r:embed="rId13"/>
                <a:stretch/>
              </p:blipFill>
              <p:spPr>
                <a:xfrm>
                  <a:off x="6381360" y="2148120"/>
                  <a:ext cx="664200" cy="4424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84" name="Group 98"/>
              <p:cNvGrpSpPr/>
              <p:nvPr/>
            </p:nvGrpSpPr>
            <p:grpSpPr>
              <a:xfrm>
                <a:off x="6970680" y="1379520"/>
                <a:ext cx="185400" cy="1103400"/>
                <a:chOff x="6970680" y="1379520"/>
                <a:chExt cx="185400" cy="1103400"/>
              </a:xfrm>
            </p:grpSpPr>
            <p:sp>
              <p:nvSpPr>
                <p:cNvPr id="85" name="Right Brace 35"/>
                <p:cNvSpPr/>
                <p:nvPr/>
              </p:nvSpPr>
              <p:spPr>
                <a:xfrm>
                  <a:off x="6970680" y="1379520"/>
                  <a:ext cx="183960" cy="322200"/>
                </a:xfrm>
                <a:custGeom>
                  <a:avLst/>
                  <a:gdLst>
                    <a:gd name="textAreaLeft" fmla="*/ 0 w 183960"/>
                    <a:gd name="textAreaRight" fmla="*/ 66240 w 183960"/>
                    <a:gd name="textAreaTop" fmla="*/ 4680 h 322200"/>
                    <a:gd name="textAreaBottom" fmla="*/ 317520 h 3222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3"/>
                        <a:pt x="10800" y="1026"/>
                      </a:cubicBezTo>
                      <a:lnTo>
                        <a:pt x="10800" y="9774"/>
                      </a:lnTo>
                      <a:cubicBezTo>
                        <a:pt x="10800" y="10287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3"/>
                        <a:pt x="10800" y="11826"/>
                      </a:cubicBezTo>
                      <a:lnTo>
                        <a:pt x="10800" y="20574"/>
                      </a:lnTo>
                      <a:cubicBezTo>
                        <a:pt x="10800" y="21087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ight Brace 36"/>
                <p:cNvSpPr/>
                <p:nvPr/>
              </p:nvSpPr>
              <p:spPr>
                <a:xfrm>
                  <a:off x="6972120" y="1770120"/>
                  <a:ext cx="183960" cy="323640"/>
                </a:xfrm>
                <a:custGeom>
                  <a:avLst/>
                  <a:gdLst>
                    <a:gd name="textAreaLeft" fmla="*/ 0 w 183960"/>
                    <a:gd name="textAreaRight" fmla="*/ 66240 w 183960"/>
                    <a:gd name="textAreaTop" fmla="*/ 4680 h 323640"/>
                    <a:gd name="textAreaBottom" fmla="*/ 318960 h 32364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1"/>
                        <a:pt x="10800" y="1021"/>
                      </a:cubicBezTo>
                      <a:lnTo>
                        <a:pt x="10800" y="9779"/>
                      </a:lnTo>
                      <a:cubicBezTo>
                        <a:pt x="10800" y="10290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1"/>
                        <a:pt x="10800" y="11821"/>
                      </a:cubicBezTo>
                      <a:lnTo>
                        <a:pt x="10800" y="20579"/>
                      </a:lnTo>
                      <a:cubicBezTo>
                        <a:pt x="10800" y="21090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Right Brace 37"/>
                <p:cNvSpPr/>
                <p:nvPr/>
              </p:nvSpPr>
              <p:spPr>
                <a:xfrm>
                  <a:off x="6970680" y="2160720"/>
                  <a:ext cx="183960" cy="322200"/>
                </a:xfrm>
                <a:custGeom>
                  <a:avLst/>
                  <a:gdLst>
                    <a:gd name="textAreaLeft" fmla="*/ 0 w 183960"/>
                    <a:gd name="textAreaRight" fmla="*/ 66240 w 183960"/>
                    <a:gd name="textAreaTop" fmla="*/ 4680 h 322200"/>
                    <a:gd name="textAreaBottom" fmla="*/ 317520 h 3222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3"/>
                        <a:pt x="10800" y="1026"/>
                      </a:cubicBezTo>
                      <a:lnTo>
                        <a:pt x="10800" y="9774"/>
                      </a:lnTo>
                      <a:cubicBezTo>
                        <a:pt x="10800" y="10287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3"/>
                        <a:pt x="10800" y="11826"/>
                      </a:cubicBezTo>
                      <a:lnTo>
                        <a:pt x="10800" y="20574"/>
                      </a:lnTo>
                      <a:cubicBezTo>
                        <a:pt x="10800" y="21087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" name="Group 96"/>
              <p:cNvGrpSpPr/>
              <p:nvPr/>
            </p:nvGrpSpPr>
            <p:grpSpPr>
              <a:xfrm>
                <a:off x="4186080" y="1229400"/>
                <a:ext cx="1522440" cy="1343520"/>
                <a:chOff x="4186080" y="1229400"/>
                <a:chExt cx="1522440" cy="1343520"/>
              </a:xfrm>
            </p:grpSpPr>
            <p:pic>
              <p:nvPicPr>
                <p:cNvPr id="89" name="Picture 12" descr=""/>
                <p:cNvPicPr/>
                <p:nvPr/>
              </p:nvPicPr>
              <p:blipFill>
                <a:blip r:embed="rId14"/>
                <a:stretch/>
              </p:blipFill>
              <p:spPr>
                <a:xfrm>
                  <a:off x="5031720" y="1354320"/>
                  <a:ext cx="662400" cy="441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0" name="Picture 13" descr=""/>
                <p:cNvPicPr/>
                <p:nvPr/>
              </p:nvPicPr>
              <p:blipFill>
                <a:blip r:embed="rId15"/>
                <a:stretch/>
              </p:blipFill>
              <p:spPr>
                <a:xfrm>
                  <a:off x="5017680" y="1728360"/>
                  <a:ext cx="690840" cy="4600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1" name="Picture 14" descr=""/>
                <p:cNvPicPr/>
                <p:nvPr/>
              </p:nvPicPr>
              <p:blipFill>
                <a:blip r:embed="rId16"/>
                <a:stretch/>
              </p:blipFill>
              <p:spPr>
                <a:xfrm>
                  <a:off x="5017680" y="2126880"/>
                  <a:ext cx="669240" cy="446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2" name="Freeform 90147"/>
                <p:cNvSpPr/>
                <p:nvPr/>
              </p:nvSpPr>
              <p:spPr>
                <a:xfrm rot="21417600">
                  <a:off x="4222080" y="1258200"/>
                  <a:ext cx="1100160" cy="215640"/>
                </a:xfrm>
                <a:custGeom>
                  <a:avLst/>
                  <a:gdLst/>
                  <a:ahLst/>
                  <a:rect l="l" t="t" r="r" b="b"/>
                  <a:pathLst>
                    <a:path w="1205346" h="215915">
                      <a:moveTo>
                        <a:pt x="0" y="215915"/>
                      </a:moveTo>
                      <a:cubicBezTo>
                        <a:pt x="147452" y="147632"/>
                        <a:pt x="294904" y="79349"/>
                        <a:pt x="463138" y="43723"/>
                      </a:cubicBezTo>
                      <a:cubicBezTo>
                        <a:pt x="631372" y="8097"/>
                        <a:pt x="885702" y="-5758"/>
                        <a:pt x="1009403" y="2159"/>
                      </a:cubicBezTo>
                      <a:cubicBezTo>
                        <a:pt x="1133104" y="10076"/>
                        <a:pt x="1205346" y="91224"/>
                        <a:pt x="1205346" y="91224"/>
                      </a:cubicBezTo>
                      <a:lnTo>
                        <a:pt x="1205346" y="91224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Straight Connector 30"/>
                <p:cNvSpPr/>
                <p:nvPr/>
              </p:nvSpPr>
              <p:spPr>
                <a:xfrm>
                  <a:off x="4186080" y="2061720"/>
                  <a:ext cx="387360" cy="1440"/>
                </a:xfrm>
                <a:prstGeom prst="line">
                  <a:avLst/>
                </a:prstGeom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94" name="Picture 55" descr=""/>
                <p:cNvPicPr/>
                <p:nvPr/>
              </p:nvPicPr>
              <p:blipFill>
                <a:blip r:embed="rId17"/>
                <a:stretch/>
              </p:blipFill>
              <p:spPr>
                <a:xfrm>
                  <a:off x="4430520" y="1339560"/>
                  <a:ext cx="674280" cy="4492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5" name="Picture 56" descr=""/>
                <p:cNvPicPr/>
                <p:nvPr/>
              </p:nvPicPr>
              <p:blipFill>
                <a:blip r:embed="rId18"/>
                <a:stretch/>
              </p:blipFill>
              <p:spPr>
                <a:xfrm>
                  <a:off x="4434120" y="1735560"/>
                  <a:ext cx="658440" cy="4384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6" name="Picture 57" descr=""/>
                <p:cNvPicPr/>
                <p:nvPr/>
              </p:nvPicPr>
              <p:blipFill>
                <a:blip r:embed="rId19"/>
                <a:stretch/>
              </p:blipFill>
              <p:spPr>
                <a:xfrm>
                  <a:off x="4431960" y="2125440"/>
                  <a:ext cx="667440" cy="4446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7" name="Freeform 90145"/>
                <p:cNvSpPr/>
                <p:nvPr/>
              </p:nvSpPr>
              <p:spPr>
                <a:xfrm rot="21369000">
                  <a:off x="4231800" y="1365840"/>
                  <a:ext cx="414360" cy="115560"/>
                </a:xfrm>
                <a:custGeom>
                  <a:avLst/>
                  <a:gdLst/>
                  <a:ahLst/>
                  <a:rect l="l" t="t" r="r" b="b"/>
                  <a:pathLst>
                    <a:path w="540327" h="168179">
                      <a:moveTo>
                        <a:pt x="0" y="168179"/>
                      </a:moveTo>
                      <a:cubicBezTo>
                        <a:pt x="139040" y="92968"/>
                        <a:pt x="278081" y="17758"/>
                        <a:pt x="368135" y="1924"/>
                      </a:cubicBezTo>
                      <a:cubicBezTo>
                        <a:pt x="458190" y="-13910"/>
                        <a:pt x="540327" y="73176"/>
                        <a:pt x="540327" y="73176"/>
                      </a:cubicBezTo>
                      <a:lnTo>
                        <a:pt x="540327" y="73176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8" name="Group 95"/>
              <p:cNvGrpSpPr/>
              <p:nvPr/>
            </p:nvGrpSpPr>
            <p:grpSpPr>
              <a:xfrm>
                <a:off x="3505320" y="1319040"/>
                <a:ext cx="919440" cy="1243080"/>
                <a:chOff x="3505320" y="1319040"/>
                <a:chExt cx="919440" cy="1243080"/>
              </a:xfrm>
            </p:grpSpPr>
            <p:pic>
              <p:nvPicPr>
                <p:cNvPr id="99" name="Picture 10" descr=""/>
                <p:cNvPicPr/>
                <p:nvPr/>
              </p:nvPicPr>
              <p:blipFill>
                <a:blip r:embed="rId20"/>
                <a:stretch/>
              </p:blipFill>
              <p:spPr>
                <a:xfrm>
                  <a:off x="3723120" y="2095200"/>
                  <a:ext cx="700200" cy="4669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0" name="Picture 8" descr=""/>
                <p:cNvPicPr/>
                <p:nvPr/>
              </p:nvPicPr>
              <p:blipFill>
                <a:blip r:embed="rId21"/>
                <a:stretch/>
              </p:blipFill>
              <p:spPr>
                <a:xfrm>
                  <a:off x="3722040" y="1715040"/>
                  <a:ext cx="699120" cy="466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1" name="Picture 6" descr=""/>
                <p:cNvPicPr/>
                <p:nvPr/>
              </p:nvPicPr>
              <p:blipFill>
                <a:blip r:embed="rId22"/>
                <a:stretch/>
              </p:blipFill>
              <p:spPr>
                <a:xfrm>
                  <a:off x="3720960" y="1319040"/>
                  <a:ext cx="703800" cy="46908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102" name="Group 23"/>
                <p:cNvGrpSpPr/>
                <p:nvPr/>
              </p:nvGrpSpPr>
              <p:grpSpPr>
                <a:xfrm>
                  <a:off x="3505320" y="1623240"/>
                  <a:ext cx="304920" cy="686880"/>
                  <a:chOff x="3505320" y="1623240"/>
                  <a:chExt cx="304920" cy="686880"/>
                </a:xfrm>
              </p:grpSpPr>
              <p:cxnSp>
                <p:nvCxnSpPr>
                  <p:cNvPr id="103" name="Straight Arrow Connector 23"/>
                  <p:cNvCxnSpPr/>
                  <p:nvPr/>
                </p:nvCxnSpPr>
                <p:spPr>
                  <a:xfrm flipV="1">
                    <a:off x="3505320" y="1623240"/>
                    <a:ext cx="305280" cy="12780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104" name="Straight Arrow Connector 24"/>
                  <p:cNvCxnSpPr/>
                  <p:nvPr/>
                </p:nvCxnSpPr>
                <p:spPr>
                  <a:xfrm>
                    <a:off x="3505320" y="2173320"/>
                    <a:ext cx="305280" cy="13716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105" name="Straight Arrow Connector 25"/>
                  <p:cNvCxnSpPr/>
                  <p:nvPr/>
                </p:nvCxnSpPr>
                <p:spPr>
                  <a:xfrm>
                    <a:off x="3580920" y="1928520"/>
                    <a:ext cx="162360" cy="108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</p:grpSp>
          </p:grpSp>
        </p:grpSp>
        <p:grpSp>
          <p:nvGrpSpPr>
            <p:cNvPr id="106" name="Group 10242"/>
            <p:cNvGrpSpPr/>
            <p:nvPr/>
          </p:nvGrpSpPr>
          <p:grpSpPr>
            <a:xfrm>
              <a:off x="1204920" y="1324080"/>
              <a:ext cx="2376360" cy="1952640"/>
              <a:chOff x="1204920" y="1324080"/>
              <a:chExt cx="2376360" cy="1952640"/>
            </a:xfrm>
          </p:grpSpPr>
          <p:pic>
            <p:nvPicPr>
              <p:cNvPr id="107" name="Picture 7" descr=""/>
              <p:cNvPicPr/>
              <p:nvPr/>
            </p:nvPicPr>
            <p:blipFill>
              <a:blip r:embed="rId23"/>
              <a:stretch/>
            </p:blipFill>
            <p:spPr>
              <a:xfrm>
                <a:off x="1976400" y="1324080"/>
                <a:ext cx="1604880" cy="106992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108" name="Straight Arrow Connector 12"/>
              <p:cNvCxnSpPr/>
              <p:nvPr/>
            </p:nvCxnSpPr>
            <p:spPr>
              <a:xfrm flipV="1">
                <a:off x="1204920" y="2330280"/>
                <a:ext cx="838800" cy="94680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</p:grpSp>
        <p:sp>
          <p:nvSpPr>
            <p:cNvPr id="109" name="TextBox 151"/>
            <p:cNvSpPr/>
            <p:nvPr/>
          </p:nvSpPr>
          <p:spPr>
            <a:xfrm>
              <a:off x="249120" y="579600"/>
              <a:ext cx="3027240" cy="947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The process (i)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9"/>
            <p:cNvSpPr/>
            <p:nvPr/>
          </p:nvSpPr>
          <p:spPr>
            <a:xfrm>
              <a:off x="4079880" y="4611960"/>
              <a:ext cx="47592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lternative (complex and dynamic) indicators can be created and explored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10"/>
            <p:cNvSpPr/>
            <p:nvPr/>
          </p:nvSpPr>
          <p:spPr>
            <a:xfrm>
              <a:off x="446040" y="4307040"/>
              <a:ext cx="305892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When classic indicators fail to discriminate outcomes,…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" name="Rectangle 56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3" name="Group 4"/>
          <p:cNvGrpSpPr/>
          <p:nvPr/>
        </p:nvGrpSpPr>
        <p:grpSpPr>
          <a:xfrm>
            <a:off x="0" y="609480"/>
            <a:ext cx="8948880" cy="6083280"/>
            <a:chOff x="0" y="609480"/>
            <a:chExt cx="8948880" cy="6083280"/>
          </a:xfrm>
        </p:grpSpPr>
        <p:grpSp>
          <p:nvGrpSpPr>
            <p:cNvPr id="114" name="Group 10242"/>
            <p:cNvGrpSpPr/>
            <p:nvPr/>
          </p:nvGrpSpPr>
          <p:grpSpPr>
            <a:xfrm>
              <a:off x="0" y="1860480"/>
              <a:ext cx="4648320" cy="3579480"/>
              <a:chOff x="0" y="1860480"/>
              <a:chExt cx="4648320" cy="3579480"/>
            </a:xfrm>
          </p:grpSpPr>
          <p:pic>
            <p:nvPicPr>
              <p:cNvPr id="115" name="Picture 7" descr=""/>
              <p:cNvPicPr/>
              <p:nvPr/>
            </p:nvPicPr>
            <p:blipFill>
              <a:blip r:embed="rId1"/>
              <a:stretch/>
            </p:blipFill>
            <p:spPr>
              <a:xfrm>
                <a:off x="639720" y="1860480"/>
                <a:ext cx="4008600" cy="283860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116" name="Straight Arrow Connector 18"/>
              <p:cNvCxnSpPr/>
              <p:nvPr/>
            </p:nvCxnSpPr>
            <p:spPr>
              <a:xfrm flipV="1">
                <a:off x="0" y="4529880"/>
                <a:ext cx="807120" cy="91044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</p:grpSp>
        <p:sp>
          <p:nvSpPr>
            <p:cNvPr id="117" name="TextBox 93"/>
            <p:cNvSpPr/>
            <p:nvPr/>
          </p:nvSpPr>
          <p:spPr>
            <a:xfrm>
              <a:off x="273960" y="609480"/>
              <a:ext cx="361224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800" spc="-1" strike="noStrike">
                  <a:solidFill>
                    <a:srgbClr val="000000"/>
                  </a:solidFill>
                  <a:latin typeface="Arial"/>
                </a:rPr>
                <a:t>The process (ii)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7"/>
            <p:cNvSpPr/>
            <p:nvPr/>
          </p:nvSpPr>
          <p:spPr>
            <a:xfrm>
              <a:off x="1090440" y="6040440"/>
              <a:ext cx="392580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800" spc="-1" strike="noStrike">
                  <a:solidFill>
                    <a:srgbClr val="184ad8"/>
                  </a:solidFill>
                  <a:latin typeface="Arial"/>
                </a:rPr>
                <a:t>Plots showing distinct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(orthogonal) data </a:t>
              </a:r>
              <a:r>
                <a:rPr b="1" i="1" lang="en-US" sz="1800" spc="-1" strike="noStrike">
                  <a:solidFill>
                    <a:srgbClr val="184ad8"/>
                  </a:solidFill>
                  <a:latin typeface="Arial"/>
                </a:rPr>
                <a:t>patterns…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8"/>
            <p:cNvSpPr/>
            <p:nvPr/>
          </p:nvSpPr>
          <p:spPr>
            <a:xfrm>
              <a:off x="5700600" y="6050160"/>
              <a:ext cx="3100680" cy="64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re assessed </a:t>
              </a:r>
              <a:r>
                <a:rPr b="1" i="1" lang="en-US" sz="1800" spc="-1" strike="noStrike">
                  <a:solidFill>
                    <a:srgbClr val="184ad8"/>
                  </a:solidFill>
                  <a:latin typeface="Arial"/>
                </a:rPr>
                <a:t>over time, …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0" name="Group 10"/>
            <p:cNvGrpSpPr/>
            <p:nvPr/>
          </p:nvGrpSpPr>
          <p:grpSpPr>
            <a:xfrm>
              <a:off x="4303440" y="718920"/>
              <a:ext cx="4645440" cy="5483520"/>
              <a:chOff x="4303440" y="718920"/>
              <a:chExt cx="4645440" cy="5483520"/>
            </a:xfrm>
          </p:grpSpPr>
          <p:pic>
            <p:nvPicPr>
              <p:cNvPr id="121" name="Picture 9" descr=""/>
              <p:cNvPicPr/>
              <p:nvPr/>
            </p:nvPicPr>
            <p:blipFill>
              <a:blip r:embed="rId2"/>
              <a:stretch/>
            </p:blipFill>
            <p:spPr>
              <a:xfrm>
                <a:off x="5638680" y="3995640"/>
                <a:ext cx="3310200" cy="2206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2" name="Picture 8" descr=""/>
              <p:cNvPicPr/>
              <p:nvPr/>
            </p:nvPicPr>
            <p:blipFill>
              <a:blip r:embed="rId3"/>
              <a:stretch/>
            </p:blipFill>
            <p:spPr>
              <a:xfrm>
                <a:off x="5638680" y="2319120"/>
                <a:ext cx="3310200" cy="2206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3" name="Picture 6" descr=""/>
              <p:cNvPicPr/>
              <p:nvPr/>
            </p:nvPicPr>
            <p:blipFill>
              <a:blip r:embed="rId4"/>
              <a:stretch/>
            </p:blipFill>
            <p:spPr>
              <a:xfrm>
                <a:off x="5647680" y="718920"/>
                <a:ext cx="3301200" cy="22006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4" name="Group 23"/>
              <p:cNvGrpSpPr/>
              <p:nvPr/>
            </p:nvGrpSpPr>
            <p:grpSpPr>
              <a:xfrm>
                <a:off x="4303440" y="1983600"/>
                <a:ext cx="1427760" cy="3196800"/>
                <a:chOff x="4303440" y="1983600"/>
                <a:chExt cx="1427760" cy="3196800"/>
              </a:xfrm>
            </p:grpSpPr>
            <p:cxnSp>
              <p:nvCxnSpPr>
                <p:cNvPr id="125" name="Straight Arrow Connector 14"/>
                <p:cNvCxnSpPr/>
                <p:nvPr/>
              </p:nvCxnSpPr>
              <p:spPr>
                <a:xfrm flipV="1">
                  <a:off x="4303440" y="1983600"/>
                  <a:ext cx="1428120" cy="59112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126" name="Straight Arrow Connector 15"/>
                <p:cNvCxnSpPr/>
                <p:nvPr/>
              </p:nvCxnSpPr>
              <p:spPr>
                <a:xfrm>
                  <a:off x="4303440" y="4543200"/>
                  <a:ext cx="1428120" cy="63756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127" name="Straight Arrow Connector 16"/>
                <p:cNvCxnSpPr/>
                <p:nvPr/>
              </p:nvCxnSpPr>
              <p:spPr>
                <a:xfrm>
                  <a:off x="4660920" y="3403800"/>
                  <a:ext cx="758160" cy="10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</p:grpSp>
        </p:grpSp>
      </p:grpSp>
      <p:sp>
        <p:nvSpPr>
          <p:cNvPr id="128" name="Rectangle 19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9" name="Group 8"/>
          <p:cNvGrpSpPr/>
          <p:nvPr/>
        </p:nvGrpSpPr>
        <p:grpSpPr>
          <a:xfrm>
            <a:off x="206280" y="187200"/>
            <a:ext cx="8798040" cy="6625800"/>
            <a:chOff x="206280" y="187200"/>
            <a:chExt cx="8798040" cy="6625800"/>
          </a:xfrm>
        </p:grpSpPr>
        <p:grpSp>
          <p:nvGrpSpPr>
            <p:cNvPr id="130" name="Group 13"/>
            <p:cNvGrpSpPr/>
            <p:nvPr/>
          </p:nvGrpSpPr>
          <p:grpSpPr>
            <a:xfrm>
              <a:off x="206280" y="198000"/>
              <a:ext cx="8798040" cy="3594600"/>
              <a:chOff x="206280" y="198000"/>
              <a:chExt cx="8798040" cy="3594600"/>
            </a:xfrm>
          </p:grpSpPr>
          <p:grpSp>
            <p:nvGrpSpPr>
              <p:cNvPr id="131" name="Group 12"/>
              <p:cNvGrpSpPr/>
              <p:nvPr/>
            </p:nvGrpSpPr>
            <p:grpSpPr>
              <a:xfrm>
                <a:off x="228600" y="2154960"/>
                <a:ext cx="8775720" cy="1637640"/>
                <a:chOff x="228600" y="2154960"/>
                <a:chExt cx="8775720" cy="1637640"/>
              </a:xfrm>
            </p:grpSpPr>
            <p:pic>
              <p:nvPicPr>
                <p:cNvPr id="132" name="Picture 2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2376720" y="2154960"/>
                  <a:ext cx="2455920" cy="1637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3" name="Picture 3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28600" y="2154960"/>
                  <a:ext cx="2392920" cy="1595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4" name="Picture 7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4647960" y="2223360"/>
                  <a:ext cx="2352960" cy="1569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35" name="Picture 6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6718320" y="2268360"/>
                  <a:ext cx="2286000" cy="15242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36" name="Group 10"/>
              <p:cNvGrpSpPr/>
              <p:nvPr/>
            </p:nvGrpSpPr>
            <p:grpSpPr>
              <a:xfrm>
                <a:off x="206280" y="198000"/>
                <a:ext cx="7140600" cy="2189880"/>
                <a:chOff x="206280" y="198000"/>
                <a:chExt cx="7140600" cy="2189880"/>
              </a:xfrm>
            </p:grpSpPr>
            <p:sp>
              <p:nvSpPr>
                <p:cNvPr id="137" name="Freeform 18"/>
                <p:cNvSpPr/>
                <p:nvPr/>
              </p:nvSpPr>
              <p:spPr>
                <a:xfrm rot="198600">
                  <a:off x="237960" y="401040"/>
                  <a:ext cx="7077240" cy="1300680"/>
                </a:xfrm>
                <a:custGeom>
                  <a:avLst/>
                  <a:gdLst/>
                  <a:ahLst/>
                  <a:rect l="l" t="t" r="r" b="b"/>
                  <a:pathLst>
                    <a:path w="1847850" h="343125">
                      <a:moveTo>
                        <a:pt x="0" y="343125"/>
                      </a:moveTo>
                      <a:cubicBezTo>
                        <a:pt x="455612" y="176437"/>
                        <a:pt x="911225" y="9750"/>
                        <a:pt x="1219200" y="225"/>
                      </a:cubicBezTo>
                      <a:cubicBezTo>
                        <a:pt x="1527175" y="-9300"/>
                        <a:pt x="1847850" y="285975"/>
                        <a:pt x="1847850" y="285975"/>
                      </a:cubicBezTo>
                      <a:lnTo>
                        <a:pt x="1847850" y="285975"/>
                      </a:ln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Freeform 90147"/>
                <p:cNvSpPr/>
                <p:nvPr/>
              </p:nvSpPr>
              <p:spPr>
                <a:xfrm rot="21417600">
                  <a:off x="258480" y="1604880"/>
                  <a:ext cx="3105360" cy="604800"/>
                </a:xfrm>
                <a:custGeom>
                  <a:avLst/>
                  <a:gdLst/>
                  <a:ahLst/>
                  <a:rect l="l" t="t" r="r" b="b"/>
                  <a:pathLst>
                    <a:path w="1205346" h="215915">
                      <a:moveTo>
                        <a:pt x="0" y="215915"/>
                      </a:moveTo>
                      <a:cubicBezTo>
                        <a:pt x="147452" y="147632"/>
                        <a:pt x="294904" y="79349"/>
                        <a:pt x="463138" y="43723"/>
                      </a:cubicBezTo>
                      <a:cubicBezTo>
                        <a:pt x="631372" y="8097"/>
                        <a:pt x="885702" y="-5758"/>
                        <a:pt x="1009403" y="2159"/>
                      </a:cubicBezTo>
                      <a:cubicBezTo>
                        <a:pt x="1133104" y="10076"/>
                        <a:pt x="1205346" y="91224"/>
                        <a:pt x="1205346" y="91224"/>
                      </a:cubicBezTo>
                      <a:lnTo>
                        <a:pt x="1205346" y="91224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Freeform 90145"/>
                <p:cNvSpPr/>
                <p:nvPr/>
              </p:nvSpPr>
              <p:spPr>
                <a:xfrm rot="21369000">
                  <a:off x="248400" y="1947960"/>
                  <a:ext cx="1292040" cy="396720"/>
                </a:xfrm>
                <a:custGeom>
                  <a:avLst/>
                  <a:gdLst/>
                  <a:ahLst/>
                  <a:rect l="l" t="t" r="r" b="b"/>
                  <a:pathLst>
                    <a:path w="540327" h="168179">
                      <a:moveTo>
                        <a:pt x="0" y="168179"/>
                      </a:moveTo>
                      <a:cubicBezTo>
                        <a:pt x="139040" y="92968"/>
                        <a:pt x="278081" y="17758"/>
                        <a:pt x="368135" y="1924"/>
                      </a:cubicBezTo>
                      <a:cubicBezTo>
                        <a:pt x="458190" y="-13910"/>
                        <a:pt x="540327" y="73176"/>
                        <a:pt x="540327" y="73176"/>
                      </a:cubicBezTo>
                      <a:lnTo>
                        <a:pt x="540327" y="73176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Freeform 21"/>
                <p:cNvSpPr/>
                <p:nvPr/>
              </p:nvSpPr>
              <p:spPr>
                <a:xfrm>
                  <a:off x="409320" y="1142640"/>
                  <a:ext cx="4934160" cy="625680"/>
                </a:xfrm>
                <a:custGeom>
                  <a:avLst/>
                  <a:gdLst/>
                  <a:ahLst/>
                  <a:rect l="l" t="t" r="r" b="b"/>
                  <a:pathLst>
                    <a:path w="1847850" h="343125">
                      <a:moveTo>
                        <a:pt x="0" y="343125"/>
                      </a:moveTo>
                      <a:cubicBezTo>
                        <a:pt x="455612" y="176437"/>
                        <a:pt x="911225" y="9750"/>
                        <a:pt x="1219200" y="225"/>
                      </a:cubicBezTo>
                      <a:cubicBezTo>
                        <a:pt x="1527175" y="-9300"/>
                        <a:pt x="1847850" y="285975"/>
                        <a:pt x="1847850" y="285975"/>
                      </a:cubicBezTo>
                      <a:lnTo>
                        <a:pt x="1847850" y="285975"/>
                      </a:ln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41" name="TextBox 10"/>
            <p:cNvSpPr/>
            <p:nvPr/>
          </p:nvSpPr>
          <p:spPr>
            <a:xfrm>
              <a:off x="1175400" y="187200"/>
              <a:ext cx="7031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…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ccording to </a:t>
              </a:r>
              <a:r>
                <a:rPr b="1" i="1" lang="en-US" sz="1800" spc="-1" strike="noStrike">
                  <a:solidFill>
                    <a:srgbClr val="184ad8"/>
                  </a:solidFill>
                  <a:latin typeface="Arial"/>
                </a:rPr>
                <a:t>outcome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, and                   </a:t>
              </a:r>
              <a:r>
                <a:rPr b="1" i="1" lang="en-US" sz="1800" spc="-1" strike="noStrike">
                  <a:solidFill>
                    <a:srgbClr val="184ad8"/>
                  </a:solidFill>
                  <a:latin typeface="Arial"/>
                </a:rPr>
                <a:t>personalize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 information.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2" name="Group 11"/>
            <p:cNvGrpSpPr/>
            <p:nvPr/>
          </p:nvGrpSpPr>
          <p:grpSpPr>
            <a:xfrm>
              <a:off x="457200" y="3844440"/>
              <a:ext cx="8420400" cy="2968560"/>
              <a:chOff x="457200" y="3844440"/>
              <a:chExt cx="8420400" cy="2968560"/>
            </a:xfrm>
          </p:grpSpPr>
          <p:sp>
            <p:nvSpPr>
              <p:cNvPr id="143" name="TextBox 54"/>
              <p:cNvSpPr/>
              <p:nvPr/>
            </p:nvSpPr>
            <p:spPr>
              <a:xfrm>
                <a:off x="1365840" y="3844440"/>
                <a:ext cx="627804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Arial"/>
                  </a:rPr>
                  <a:t>Then, data subsets (patterns) are </a:t>
                </a:r>
                <a:r>
                  <a:rPr b="1" i="1" lang="en-US" sz="2000" spc="-1" strike="noStrike">
                    <a:solidFill>
                      <a:srgbClr val="184ad8"/>
                    </a:solidFill>
                    <a:latin typeface="Arial"/>
                  </a:rPr>
                  <a:t>explicitly validate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TextBox 13"/>
              <p:cNvSpPr/>
              <p:nvPr/>
            </p:nvSpPr>
            <p:spPr>
              <a:xfrm>
                <a:off x="457200" y="6232320"/>
                <a:ext cx="842040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 Narrow"/>
                  </a:rPr>
                  <a:t>L, N, or M %: lymphocyte, neutrophil or monocyte %; L/M: lymphocyte % / monocyte %; N/L: neutrophil% / lymphocyte %; M/N: monocyte% / neutrophil%; [L/M]/[N/L]: the L/M ratio over the N/L ratio.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45" name="Picture 1" descr=""/>
              <p:cNvPicPr/>
              <p:nvPr/>
            </p:nvPicPr>
            <p:blipFill>
              <a:blip r:embed="rId5"/>
              <a:stretch/>
            </p:blipFill>
            <p:spPr>
              <a:xfrm>
                <a:off x="985680" y="4222440"/>
                <a:ext cx="3090960" cy="206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6" name="Picture 2" descr=""/>
              <p:cNvPicPr/>
              <p:nvPr/>
            </p:nvPicPr>
            <p:blipFill>
              <a:blip r:embed="rId6"/>
              <a:stretch/>
            </p:blipFill>
            <p:spPr>
              <a:xfrm>
                <a:off x="4635360" y="4267800"/>
                <a:ext cx="3022920" cy="201528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  <p:sp>
        <p:nvSpPr>
          <p:cNvPr id="147" name="Rectangle 26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Rectangle 4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9" name="Group 7"/>
          <p:cNvGrpSpPr/>
          <p:nvPr/>
        </p:nvGrpSpPr>
        <p:grpSpPr>
          <a:xfrm>
            <a:off x="290880" y="515880"/>
            <a:ext cx="8569440" cy="6298560"/>
            <a:chOff x="290880" y="515880"/>
            <a:chExt cx="8569440" cy="6298560"/>
          </a:xfrm>
        </p:grpSpPr>
        <p:sp>
          <p:nvSpPr>
            <p:cNvPr id="150" name="TextBox 6"/>
            <p:cNvSpPr/>
            <p:nvPr/>
          </p:nvSpPr>
          <p:spPr>
            <a:xfrm>
              <a:off x="290880" y="5932440"/>
              <a:ext cx="8569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x      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  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x  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         5          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x 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                 =  150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   (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x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  7 = 1050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6"/>
            <p:cNvSpPr/>
            <p:nvPr/>
          </p:nvSpPr>
          <p:spPr>
            <a:xfrm>
              <a:off x="411840" y="6202800"/>
              <a:ext cx="8360640" cy="61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 Narrow"/>
                </a:rPr>
                <a:t>This design measures:             </a:t>
              </a:r>
              <a:r>
                <a:rPr b="1" i="1" lang="en-US" sz="1600" spc="-1" strike="noStrike">
                  <a:solidFill>
                    <a:srgbClr val="c00000"/>
                  </a:solidFill>
                  <a:latin typeface="Arial Narrow"/>
                </a:rPr>
                <a:t>pattern</a:t>
              </a:r>
              <a:r>
                <a:rPr b="0" lang="en-US" sz="1600" spc="-1" strike="noStrike">
                  <a:solidFill>
                    <a:srgbClr val="c00000"/>
                  </a:solidFill>
                  <a:latin typeface="Arial Narrow"/>
                </a:rPr>
                <a:t>→ </a:t>
              </a:r>
              <a:r>
                <a:rPr b="1" i="1" lang="en-US" sz="1600" spc="-1" strike="noStrike">
                  <a:solidFill>
                    <a:srgbClr val="c00000"/>
                  </a:solidFill>
                  <a:latin typeface="Arial Narrow"/>
                </a:rPr>
                <a:t>time</a:t>
              </a:r>
              <a:r>
                <a:rPr b="0" lang="en-US" sz="1600" spc="-1" strike="noStrike">
                  <a:solidFill>
                    <a:srgbClr val="c00000"/>
                  </a:solidFill>
                  <a:latin typeface="Arial Narrow"/>
                </a:rPr>
                <a:t>→ </a:t>
              </a:r>
              <a:r>
                <a:rPr b="1" i="1" lang="en-US" sz="1600" spc="-1" strike="noStrike">
                  <a:solidFill>
                    <a:srgbClr val="c00000"/>
                  </a:solidFill>
                  <a:latin typeface="Arial Narrow"/>
                </a:rPr>
                <a:t>outcome</a:t>
              </a:r>
              <a:r>
                <a:rPr b="0" lang="en-US" sz="1600" spc="-1" strike="noStrike">
                  <a:solidFill>
                    <a:srgbClr val="c00000"/>
                  </a:solidFill>
                  <a:latin typeface="Arial Narrow"/>
                </a:rPr>
                <a:t>→ </a:t>
              </a:r>
              <a:r>
                <a:rPr b="1" i="1" lang="en-US" sz="1600" spc="-1" strike="noStrike">
                  <a:solidFill>
                    <a:srgbClr val="c00000"/>
                  </a:solidFill>
                  <a:latin typeface="Arial Narrow"/>
                </a:rPr>
                <a:t>personalized</a:t>
              </a:r>
              <a:r>
                <a:rPr b="0" lang="en-US" sz="1600" spc="-1" strike="noStrike">
                  <a:solidFill>
                    <a:srgbClr val="c00000"/>
                  </a:solidFill>
                  <a:latin typeface="Arial Narrow"/>
                </a:rPr>
                <a:t>  data→ </a:t>
              </a:r>
              <a:r>
                <a:rPr b="1" i="1" lang="en-US" sz="1600" spc="-1" strike="noStrike">
                  <a:solidFill>
                    <a:srgbClr val="c00000"/>
                  </a:solidFill>
                  <a:latin typeface="Arial Narrow"/>
                </a:rPr>
                <a:t>pathogenesis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(Note: not all combinations are shown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2" name="Picture 5" descr=""/>
            <p:cNvPicPr/>
            <p:nvPr/>
          </p:nvPicPr>
          <p:blipFill>
            <a:blip r:embed="rId1"/>
            <a:stretch/>
          </p:blipFill>
          <p:spPr>
            <a:xfrm>
              <a:off x="304920" y="2724480"/>
              <a:ext cx="1912320" cy="1255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3" name="Group 10243"/>
            <p:cNvGrpSpPr/>
            <p:nvPr/>
          </p:nvGrpSpPr>
          <p:grpSpPr>
            <a:xfrm>
              <a:off x="4523400" y="2232360"/>
              <a:ext cx="4026960" cy="3575880"/>
              <a:chOff x="4523400" y="2232360"/>
              <a:chExt cx="4026960" cy="3575880"/>
            </a:xfrm>
          </p:grpSpPr>
          <p:pic>
            <p:nvPicPr>
              <p:cNvPr id="154" name="Picture 79871" descr=""/>
              <p:cNvPicPr/>
              <p:nvPr/>
            </p:nvPicPr>
            <p:blipFill>
              <a:blip r:embed="rId2"/>
              <a:stretch/>
            </p:blipFill>
            <p:spPr>
              <a:xfrm>
                <a:off x="6405120" y="3386160"/>
                <a:ext cx="638640" cy="420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5" name="Picture 3" descr=""/>
              <p:cNvPicPr/>
              <p:nvPr/>
            </p:nvPicPr>
            <p:blipFill>
              <a:blip r:embed="rId3"/>
              <a:stretch/>
            </p:blipFill>
            <p:spPr>
              <a:xfrm>
                <a:off x="5101560" y="2239560"/>
                <a:ext cx="640080" cy="42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6" name="Picture 4" descr=""/>
              <p:cNvPicPr/>
              <p:nvPr/>
            </p:nvPicPr>
            <p:blipFill>
              <a:blip r:embed="rId4"/>
              <a:stretch/>
            </p:blipFill>
            <p:spPr>
              <a:xfrm>
                <a:off x="5092200" y="2584440"/>
                <a:ext cx="654480" cy="430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7" name="Picture 7" descr=""/>
              <p:cNvPicPr/>
              <p:nvPr/>
            </p:nvPicPr>
            <p:blipFill>
              <a:blip r:embed="rId5"/>
              <a:stretch/>
            </p:blipFill>
            <p:spPr>
              <a:xfrm>
                <a:off x="5105880" y="2949120"/>
                <a:ext cx="622800" cy="408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8" name="Picture 18" descr=""/>
              <p:cNvPicPr/>
              <p:nvPr/>
            </p:nvPicPr>
            <p:blipFill>
              <a:blip r:embed="rId6"/>
              <a:stretch/>
            </p:blipFill>
            <p:spPr>
              <a:xfrm>
                <a:off x="4536000" y="3400560"/>
                <a:ext cx="615960" cy="404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59" name="Picture 17" descr=""/>
              <p:cNvPicPr/>
              <p:nvPr/>
            </p:nvPicPr>
            <p:blipFill>
              <a:blip r:embed="rId7"/>
              <a:stretch/>
            </p:blipFill>
            <p:spPr>
              <a:xfrm>
                <a:off x="4543200" y="3756960"/>
                <a:ext cx="612720" cy="4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0" name="Picture 16" descr=""/>
              <p:cNvPicPr/>
              <p:nvPr/>
            </p:nvPicPr>
            <p:blipFill>
              <a:blip r:embed="rId8"/>
              <a:stretch/>
            </p:blipFill>
            <p:spPr>
              <a:xfrm>
                <a:off x="4548240" y="4101480"/>
                <a:ext cx="605160" cy="396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1" name="Picture 20" descr=""/>
              <p:cNvPicPr/>
              <p:nvPr/>
            </p:nvPicPr>
            <p:blipFill>
              <a:blip r:embed="rId9"/>
              <a:stretch/>
            </p:blipFill>
            <p:spPr>
              <a:xfrm>
                <a:off x="5112000" y="3409200"/>
                <a:ext cx="622080" cy="40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2" name="Picture 19" descr=""/>
              <p:cNvPicPr/>
              <p:nvPr/>
            </p:nvPicPr>
            <p:blipFill>
              <a:blip r:embed="rId10"/>
              <a:stretch/>
            </p:blipFill>
            <p:spPr>
              <a:xfrm>
                <a:off x="5130720" y="3760200"/>
                <a:ext cx="611280" cy="401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3" name="Picture 15" descr=""/>
              <p:cNvPicPr/>
              <p:nvPr/>
            </p:nvPicPr>
            <p:blipFill>
              <a:blip r:embed="rId11"/>
              <a:stretch/>
            </p:blipFill>
            <p:spPr>
              <a:xfrm>
                <a:off x="5130720" y="4105440"/>
                <a:ext cx="611280" cy="401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4" name="Picture 79916" descr=""/>
              <p:cNvPicPr/>
              <p:nvPr/>
            </p:nvPicPr>
            <p:blipFill>
              <a:blip r:embed="rId12"/>
              <a:stretch/>
            </p:blipFill>
            <p:spPr>
              <a:xfrm>
                <a:off x="7297200" y="2333160"/>
                <a:ext cx="534600" cy="349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5" name="Picture 79917" descr=""/>
              <p:cNvPicPr/>
              <p:nvPr/>
            </p:nvPicPr>
            <p:blipFill>
              <a:blip r:embed="rId13"/>
              <a:stretch/>
            </p:blipFill>
            <p:spPr>
              <a:xfrm>
                <a:off x="7281720" y="2724120"/>
                <a:ext cx="552960" cy="363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6" name="Picture 79919" descr=""/>
              <p:cNvPicPr/>
              <p:nvPr/>
            </p:nvPicPr>
            <p:blipFill>
              <a:blip r:embed="rId14"/>
              <a:stretch/>
            </p:blipFill>
            <p:spPr>
              <a:xfrm>
                <a:off x="7292520" y="3088080"/>
                <a:ext cx="543600" cy="356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7" name="Picture 79920" descr=""/>
              <p:cNvPicPr/>
              <p:nvPr/>
            </p:nvPicPr>
            <p:blipFill>
              <a:blip r:embed="rId15"/>
              <a:stretch/>
            </p:blipFill>
            <p:spPr>
              <a:xfrm>
                <a:off x="7283520" y="3448800"/>
                <a:ext cx="551520" cy="36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8" name="Picture 79921" descr=""/>
              <p:cNvPicPr/>
              <p:nvPr/>
            </p:nvPicPr>
            <p:blipFill>
              <a:blip r:embed="rId16"/>
              <a:stretch/>
            </p:blipFill>
            <p:spPr>
              <a:xfrm>
                <a:off x="7274160" y="3802320"/>
                <a:ext cx="565200" cy="371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69" name="Picture 79922" descr=""/>
              <p:cNvPicPr/>
              <p:nvPr/>
            </p:nvPicPr>
            <p:blipFill>
              <a:blip r:embed="rId17"/>
              <a:stretch/>
            </p:blipFill>
            <p:spPr>
              <a:xfrm>
                <a:off x="7274160" y="4173480"/>
                <a:ext cx="554400" cy="363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0" name="Picture 15" descr=""/>
              <p:cNvPicPr/>
              <p:nvPr/>
            </p:nvPicPr>
            <p:blipFill>
              <a:blip r:embed="rId18"/>
              <a:stretch/>
            </p:blipFill>
            <p:spPr>
              <a:xfrm>
                <a:off x="7983720" y="2325960"/>
                <a:ext cx="564120" cy="36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1" name="Picture 16" descr=""/>
              <p:cNvPicPr/>
              <p:nvPr/>
            </p:nvPicPr>
            <p:blipFill>
              <a:blip r:embed="rId19"/>
              <a:stretch/>
            </p:blipFill>
            <p:spPr>
              <a:xfrm>
                <a:off x="7979040" y="2725920"/>
                <a:ext cx="562320" cy="36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2" name="Picture 17" descr=""/>
              <p:cNvPicPr/>
              <p:nvPr/>
            </p:nvPicPr>
            <p:blipFill>
              <a:blip r:embed="rId20"/>
              <a:stretch/>
            </p:blipFill>
            <p:spPr>
              <a:xfrm>
                <a:off x="7975800" y="3088080"/>
                <a:ext cx="551520" cy="36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3" name="Picture 15" descr=""/>
              <p:cNvPicPr/>
              <p:nvPr/>
            </p:nvPicPr>
            <p:blipFill>
              <a:blip r:embed="rId21"/>
              <a:stretch/>
            </p:blipFill>
            <p:spPr>
              <a:xfrm>
                <a:off x="7979040" y="3448800"/>
                <a:ext cx="571320" cy="374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4" name="Picture 16" descr=""/>
              <p:cNvPicPr/>
              <p:nvPr/>
            </p:nvPicPr>
            <p:blipFill>
              <a:blip r:embed="rId22"/>
              <a:stretch/>
            </p:blipFill>
            <p:spPr>
              <a:xfrm>
                <a:off x="7979040" y="3812760"/>
                <a:ext cx="562320" cy="36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5" name="Picture 17" descr=""/>
              <p:cNvPicPr/>
              <p:nvPr/>
            </p:nvPicPr>
            <p:blipFill>
              <a:blip r:embed="rId23"/>
              <a:stretch/>
            </p:blipFill>
            <p:spPr>
              <a:xfrm>
                <a:off x="7979040" y="4173480"/>
                <a:ext cx="551520" cy="36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6" name="Picture 10" descr=""/>
              <p:cNvPicPr/>
              <p:nvPr/>
            </p:nvPicPr>
            <p:blipFill>
              <a:blip r:embed="rId24"/>
              <a:stretch/>
            </p:blipFill>
            <p:spPr>
              <a:xfrm>
                <a:off x="5797080" y="3394080"/>
                <a:ext cx="622800" cy="40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7" name="Picture 12" descr=""/>
              <p:cNvPicPr/>
              <p:nvPr/>
            </p:nvPicPr>
            <p:blipFill>
              <a:blip r:embed="rId25"/>
              <a:stretch/>
            </p:blipFill>
            <p:spPr>
              <a:xfrm>
                <a:off x="5791320" y="3776760"/>
                <a:ext cx="627120" cy="412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8" name="Picture 14" descr=""/>
              <p:cNvPicPr/>
              <p:nvPr/>
            </p:nvPicPr>
            <p:blipFill>
              <a:blip r:embed="rId26"/>
              <a:stretch/>
            </p:blipFill>
            <p:spPr>
              <a:xfrm>
                <a:off x="5799600" y="4131360"/>
                <a:ext cx="618120" cy="404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79" name="Picture 25" descr=""/>
              <p:cNvPicPr/>
              <p:nvPr/>
            </p:nvPicPr>
            <p:blipFill>
              <a:blip r:embed="rId27"/>
              <a:stretch/>
            </p:blipFill>
            <p:spPr>
              <a:xfrm>
                <a:off x="6423120" y="3809880"/>
                <a:ext cx="624960" cy="40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0" name="Picture 14" descr=""/>
              <p:cNvPicPr/>
              <p:nvPr/>
            </p:nvPicPr>
            <p:blipFill>
              <a:blip r:embed="rId28"/>
              <a:stretch/>
            </p:blipFill>
            <p:spPr>
              <a:xfrm>
                <a:off x="5119200" y="4941720"/>
                <a:ext cx="652680" cy="428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1" name="Picture 80935" descr=""/>
              <p:cNvPicPr/>
              <p:nvPr/>
            </p:nvPicPr>
            <p:blipFill>
              <a:blip r:embed="rId29"/>
              <a:stretch/>
            </p:blipFill>
            <p:spPr>
              <a:xfrm>
                <a:off x="4523400" y="4555800"/>
                <a:ext cx="657000" cy="43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2" name="Picture 5" descr=""/>
              <p:cNvPicPr/>
              <p:nvPr/>
            </p:nvPicPr>
            <p:blipFill>
              <a:blip r:embed="rId30"/>
              <a:stretch/>
            </p:blipFill>
            <p:spPr>
              <a:xfrm>
                <a:off x="5125680" y="5378400"/>
                <a:ext cx="611280" cy="401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3" name="Picture 26" descr=""/>
              <p:cNvPicPr/>
              <p:nvPr/>
            </p:nvPicPr>
            <p:blipFill>
              <a:blip r:embed="rId31"/>
              <a:stretch/>
            </p:blipFill>
            <p:spPr>
              <a:xfrm>
                <a:off x="4550760" y="4941360"/>
                <a:ext cx="652680" cy="428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4" name="Picture 30" descr=""/>
              <p:cNvPicPr/>
              <p:nvPr/>
            </p:nvPicPr>
            <p:blipFill>
              <a:blip r:embed="rId32"/>
              <a:stretch/>
            </p:blipFill>
            <p:spPr>
              <a:xfrm>
                <a:off x="5797080" y="4572000"/>
                <a:ext cx="604080" cy="396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5" name="Picture 90112" descr=""/>
              <p:cNvPicPr/>
              <p:nvPr/>
            </p:nvPicPr>
            <p:blipFill>
              <a:blip r:embed="rId33"/>
              <a:stretch/>
            </p:blipFill>
            <p:spPr>
              <a:xfrm>
                <a:off x="5778360" y="5379840"/>
                <a:ext cx="620280" cy="407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6" name="Picture 90117" descr=""/>
              <p:cNvPicPr/>
              <p:nvPr/>
            </p:nvPicPr>
            <p:blipFill>
              <a:blip r:embed="rId34"/>
              <a:stretch/>
            </p:blipFill>
            <p:spPr>
              <a:xfrm>
                <a:off x="5799600" y="4972320"/>
                <a:ext cx="601560" cy="395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7" name="Picture 14" descr=""/>
              <p:cNvPicPr/>
              <p:nvPr/>
            </p:nvPicPr>
            <p:blipFill>
              <a:blip r:embed="rId35"/>
              <a:stretch/>
            </p:blipFill>
            <p:spPr>
              <a:xfrm>
                <a:off x="4551840" y="5358600"/>
                <a:ext cx="612720" cy="4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8" name="Picture 1" descr=""/>
              <p:cNvPicPr/>
              <p:nvPr/>
            </p:nvPicPr>
            <p:blipFill>
              <a:blip r:embed="rId36"/>
              <a:stretch/>
            </p:blipFill>
            <p:spPr>
              <a:xfrm>
                <a:off x="7965360" y="4572000"/>
                <a:ext cx="563760" cy="36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89" name="Picture 9" descr=""/>
              <p:cNvPicPr/>
              <p:nvPr/>
            </p:nvPicPr>
            <p:blipFill>
              <a:blip r:embed="rId37"/>
              <a:stretch/>
            </p:blipFill>
            <p:spPr>
              <a:xfrm>
                <a:off x="7968240" y="5003640"/>
                <a:ext cx="562320" cy="36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0" name="Picture 10" descr=""/>
              <p:cNvPicPr/>
              <p:nvPr/>
            </p:nvPicPr>
            <p:blipFill>
              <a:blip r:embed="rId38"/>
              <a:stretch/>
            </p:blipFill>
            <p:spPr>
              <a:xfrm>
                <a:off x="7975800" y="5446080"/>
                <a:ext cx="551520" cy="362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1" name="Picture 26" descr=""/>
              <p:cNvPicPr/>
              <p:nvPr/>
            </p:nvPicPr>
            <p:blipFill>
              <a:blip r:embed="rId39"/>
              <a:stretch/>
            </p:blipFill>
            <p:spPr>
              <a:xfrm>
                <a:off x="7274160" y="5441400"/>
                <a:ext cx="557640" cy="366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2" name="Picture 28" descr=""/>
              <p:cNvPicPr/>
              <p:nvPr/>
            </p:nvPicPr>
            <p:blipFill>
              <a:blip r:embed="rId40"/>
              <a:stretch/>
            </p:blipFill>
            <p:spPr>
              <a:xfrm>
                <a:off x="7278840" y="5011200"/>
                <a:ext cx="545400" cy="359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3" name="Picture 90119" descr=""/>
              <p:cNvPicPr/>
              <p:nvPr/>
            </p:nvPicPr>
            <p:blipFill>
              <a:blip r:embed="rId41"/>
              <a:stretch/>
            </p:blipFill>
            <p:spPr>
              <a:xfrm>
                <a:off x="7266600" y="4564440"/>
                <a:ext cx="556200" cy="365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4" name="Picture 12" descr=""/>
              <p:cNvPicPr/>
              <p:nvPr/>
            </p:nvPicPr>
            <p:blipFill>
              <a:blip r:embed="rId42"/>
              <a:stretch/>
            </p:blipFill>
            <p:spPr>
              <a:xfrm>
                <a:off x="5107320" y="4572000"/>
                <a:ext cx="637200" cy="419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5" name="Picture 13" descr=""/>
              <p:cNvPicPr/>
              <p:nvPr/>
            </p:nvPicPr>
            <p:blipFill>
              <a:blip r:embed="rId43"/>
              <a:stretch/>
            </p:blipFill>
            <p:spPr>
              <a:xfrm>
                <a:off x="4536000" y="2232360"/>
                <a:ext cx="641880" cy="422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6" name="Picture 100" descr=""/>
              <p:cNvPicPr/>
              <p:nvPr/>
            </p:nvPicPr>
            <p:blipFill>
              <a:blip r:embed="rId44"/>
              <a:stretch/>
            </p:blipFill>
            <p:spPr>
              <a:xfrm>
                <a:off x="5760360" y="2240640"/>
                <a:ext cx="669600" cy="439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7" name="Picture 15" descr=""/>
              <p:cNvPicPr/>
              <p:nvPr/>
            </p:nvPicPr>
            <p:blipFill>
              <a:blip r:embed="rId45"/>
              <a:stretch/>
            </p:blipFill>
            <p:spPr>
              <a:xfrm>
                <a:off x="4523400" y="2580840"/>
                <a:ext cx="652680" cy="428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8" name="Picture 90157" descr=""/>
              <p:cNvPicPr/>
              <p:nvPr/>
            </p:nvPicPr>
            <p:blipFill>
              <a:blip r:embed="rId46"/>
              <a:stretch/>
            </p:blipFill>
            <p:spPr>
              <a:xfrm>
                <a:off x="4525920" y="2933280"/>
                <a:ext cx="646920" cy="424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99" name="Picture 98" descr=""/>
              <p:cNvPicPr/>
              <p:nvPr/>
            </p:nvPicPr>
            <p:blipFill>
              <a:blip r:embed="rId47"/>
              <a:stretch/>
            </p:blipFill>
            <p:spPr>
              <a:xfrm>
                <a:off x="5760360" y="2608560"/>
                <a:ext cx="664920" cy="437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0" name="Picture 99" descr=""/>
              <p:cNvPicPr/>
              <p:nvPr/>
            </p:nvPicPr>
            <p:blipFill>
              <a:blip r:embed="rId48"/>
              <a:stretch/>
            </p:blipFill>
            <p:spPr>
              <a:xfrm>
                <a:off x="5754600" y="2967840"/>
                <a:ext cx="658080" cy="432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1" name="Picture 26" descr=""/>
              <p:cNvPicPr/>
              <p:nvPr/>
            </p:nvPicPr>
            <p:blipFill>
              <a:blip r:embed="rId49"/>
              <a:stretch/>
            </p:blipFill>
            <p:spPr>
              <a:xfrm>
                <a:off x="6410520" y="2251440"/>
                <a:ext cx="651600" cy="428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2" name="Picture 90160" descr=""/>
              <p:cNvPicPr/>
              <p:nvPr/>
            </p:nvPicPr>
            <p:blipFill>
              <a:blip r:embed="rId50"/>
              <a:stretch/>
            </p:blipFill>
            <p:spPr>
              <a:xfrm>
                <a:off x="6409440" y="2611440"/>
                <a:ext cx="650160" cy="426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3" name="Picture 90174" descr=""/>
              <p:cNvPicPr/>
              <p:nvPr/>
            </p:nvPicPr>
            <p:blipFill>
              <a:blip r:embed="rId51"/>
              <a:stretch/>
            </p:blipFill>
            <p:spPr>
              <a:xfrm>
                <a:off x="6425640" y="2970360"/>
                <a:ext cx="620280" cy="407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4" name="Right Brace 142"/>
              <p:cNvSpPr/>
              <p:nvPr/>
            </p:nvSpPr>
            <p:spPr>
              <a:xfrm>
                <a:off x="6978600" y="3441240"/>
                <a:ext cx="174600" cy="36036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60360"/>
                  <a:gd name="textAreaBottom" fmla="*/ 356040 h 3603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30"/>
                      <a:pt x="10800" y="859"/>
                    </a:cubicBezTo>
                    <a:lnTo>
                      <a:pt x="10800" y="9941"/>
                    </a:lnTo>
                    <a:cubicBezTo>
                      <a:pt x="10800" y="10371"/>
                      <a:pt x="16200" y="10800"/>
                      <a:pt x="21600" y="10800"/>
                    </a:cubicBezTo>
                    <a:cubicBezTo>
                      <a:pt x="16200" y="10800"/>
                      <a:pt x="10800" y="11230"/>
                      <a:pt x="10800" y="11659"/>
                    </a:cubicBezTo>
                    <a:lnTo>
                      <a:pt x="10800" y="20741"/>
                    </a:lnTo>
                    <a:cubicBezTo>
                      <a:pt x="10800" y="21171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ight Brace 143"/>
              <p:cNvSpPr/>
              <p:nvPr/>
            </p:nvSpPr>
            <p:spPr>
              <a:xfrm>
                <a:off x="6978600" y="3820680"/>
                <a:ext cx="174600" cy="36828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68280"/>
                  <a:gd name="textAreaBottom" fmla="*/ 363960 h 368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21"/>
                      <a:pt x="10800" y="841"/>
                    </a:cubicBezTo>
                    <a:lnTo>
                      <a:pt x="10800" y="9959"/>
                    </a:lnTo>
                    <a:cubicBezTo>
                      <a:pt x="10800" y="10380"/>
                      <a:pt x="16200" y="10800"/>
                      <a:pt x="21600" y="10800"/>
                    </a:cubicBezTo>
                    <a:cubicBezTo>
                      <a:pt x="16200" y="10800"/>
                      <a:pt x="10800" y="11221"/>
                      <a:pt x="10800" y="11641"/>
                    </a:cubicBezTo>
                    <a:lnTo>
                      <a:pt x="10800" y="20759"/>
                    </a:lnTo>
                    <a:cubicBezTo>
                      <a:pt x="10800" y="21180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ight Brace 144"/>
              <p:cNvSpPr/>
              <p:nvPr/>
            </p:nvSpPr>
            <p:spPr>
              <a:xfrm>
                <a:off x="6978600" y="2273040"/>
                <a:ext cx="176040" cy="338040"/>
              </a:xfrm>
              <a:custGeom>
                <a:avLst/>
                <a:gdLst>
                  <a:gd name="textAreaLeft" fmla="*/ 0 w 176040"/>
                  <a:gd name="textAreaRight" fmla="*/ 63360 w 176040"/>
                  <a:gd name="textAreaTop" fmla="*/ 4320 h 338040"/>
                  <a:gd name="textAreaBottom" fmla="*/ 333720 h 338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62"/>
                      <a:pt x="10800" y="924"/>
                    </a:cubicBezTo>
                    <a:lnTo>
                      <a:pt x="10800" y="9876"/>
                    </a:lnTo>
                    <a:cubicBezTo>
                      <a:pt x="10800" y="10338"/>
                      <a:pt x="16200" y="10800"/>
                      <a:pt x="21600" y="10800"/>
                    </a:cubicBezTo>
                    <a:cubicBezTo>
                      <a:pt x="16200" y="10800"/>
                      <a:pt x="10800" y="11262"/>
                      <a:pt x="10800" y="11724"/>
                    </a:cubicBezTo>
                    <a:lnTo>
                      <a:pt x="10800" y="20676"/>
                    </a:lnTo>
                    <a:cubicBezTo>
                      <a:pt x="10800" y="21138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ight Brace 145"/>
              <p:cNvSpPr/>
              <p:nvPr/>
            </p:nvSpPr>
            <p:spPr>
              <a:xfrm>
                <a:off x="6978600" y="2642760"/>
                <a:ext cx="174600" cy="33804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38040"/>
                  <a:gd name="textAreaBottom" fmla="*/ 333720 h 338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58"/>
                      <a:pt x="10800" y="916"/>
                    </a:cubicBezTo>
                    <a:lnTo>
                      <a:pt x="10800" y="9884"/>
                    </a:lnTo>
                    <a:cubicBezTo>
                      <a:pt x="10800" y="10342"/>
                      <a:pt x="16200" y="10800"/>
                      <a:pt x="21600" y="10800"/>
                    </a:cubicBezTo>
                    <a:cubicBezTo>
                      <a:pt x="16200" y="10800"/>
                      <a:pt x="10800" y="11258"/>
                      <a:pt x="10800" y="11716"/>
                    </a:cubicBezTo>
                    <a:lnTo>
                      <a:pt x="10800" y="20684"/>
                    </a:lnTo>
                    <a:cubicBezTo>
                      <a:pt x="10800" y="21142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ight Brace 146"/>
              <p:cNvSpPr/>
              <p:nvPr/>
            </p:nvSpPr>
            <p:spPr>
              <a:xfrm>
                <a:off x="6978600" y="3015720"/>
                <a:ext cx="174600" cy="33804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38040"/>
                  <a:gd name="textAreaBottom" fmla="*/ 333720 h 338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58"/>
                      <a:pt x="10800" y="916"/>
                    </a:cubicBezTo>
                    <a:lnTo>
                      <a:pt x="10800" y="9884"/>
                    </a:lnTo>
                    <a:cubicBezTo>
                      <a:pt x="10800" y="10342"/>
                      <a:pt x="16200" y="10800"/>
                      <a:pt x="21600" y="10800"/>
                    </a:cubicBezTo>
                    <a:cubicBezTo>
                      <a:pt x="16200" y="10800"/>
                      <a:pt x="10800" y="11258"/>
                      <a:pt x="10800" y="11716"/>
                    </a:cubicBezTo>
                    <a:lnTo>
                      <a:pt x="10800" y="20684"/>
                    </a:lnTo>
                    <a:cubicBezTo>
                      <a:pt x="10800" y="21142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09" name="Picture 9" descr=""/>
              <p:cNvPicPr/>
              <p:nvPr/>
            </p:nvPicPr>
            <p:blipFill>
              <a:blip r:embed="rId52"/>
              <a:stretch/>
            </p:blipFill>
            <p:spPr>
              <a:xfrm>
                <a:off x="6413040" y="4163040"/>
                <a:ext cx="637920" cy="419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0" name="Picture 90143" descr=""/>
              <p:cNvPicPr/>
              <p:nvPr/>
            </p:nvPicPr>
            <p:blipFill>
              <a:blip r:embed="rId53"/>
              <a:stretch/>
            </p:blipFill>
            <p:spPr>
              <a:xfrm>
                <a:off x="6420240" y="4576680"/>
                <a:ext cx="629640" cy="413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1" name="Picture 17" descr=""/>
              <p:cNvPicPr/>
              <p:nvPr/>
            </p:nvPicPr>
            <p:blipFill>
              <a:blip r:embed="rId54"/>
              <a:stretch/>
            </p:blipFill>
            <p:spPr>
              <a:xfrm>
                <a:off x="6420600" y="4955040"/>
                <a:ext cx="623160" cy="409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2" name="Picture 90130" descr=""/>
              <p:cNvPicPr/>
              <p:nvPr/>
            </p:nvPicPr>
            <p:blipFill>
              <a:blip r:embed="rId55"/>
              <a:stretch/>
            </p:blipFill>
            <p:spPr>
              <a:xfrm>
                <a:off x="6413040" y="5371920"/>
                <a:ext cx="635040" cy="4186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3" name="Right Brace 151"/>
              <p:cNvSpPr/>
              <p:nvPr/>
            </p:nvSpPr>
            <p:spPr>
              <a:xfrm>
                <a:off x="6973920" y="4987800"/>
                <a:ext cx="174600" cy="35856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58560"/>
                  <a:gd name="textAreaBottom" fmla="*/ 354240 h 358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32"/>
                      <a:pt x="10800" y="863"/>
                    </a:cubicBezTo>
                    <a:lnTo>
                      <a:pt x="10800" y="9937"/>
                    </a:lnTo>
                    <a:cubicBezTo>
                      <a:pt x="10800" y="10369"/>
                      <a:pt x="16200" y="10800"/>
                      <a:pt x="21600" y="10800"/>
                    </a:cubicBezTo>
                    <a:cubicBezTo>
                      <a:pt x="16200" y="10800"/>
                      <a:pt x="10800" y="11232"/>
                      <a:pt x="10800" y="11663"/>
                    </a:cubicBezTo>
                    <a:lnTo>
                      <a:pt x="10800" y="20737"/>
                    </a:lnTo>
                    <a:cubicBezTo>
                      <a:pt x="10800" y="21169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ight Brace 152"/>
              <p:cNvSpPr/>
              <p:nvPr/>
            </p:nvSpPr>
            <p:spPr>
              <a:xfrm>
                <a:off x="6977160" y="5376600"/>
                <a:ext cx="174600" cy="38556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85560"/>
                  <a:gd name="textAreaBottom" fmla="*/ 381240 h 385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02"/>
                      <a:pt x="10800" y="803"/>
                    </a:cubicBezTo>
                    <a:lnTo>
                      <a:pt x="10800" y="9997"/>
                    </a:lnTo>
                    <a:cubicBezTo>
                      <a:pt x="10800" y="10399"/>
                      <a:pt x="16200" y="10800"/>
                      <a:pt x="21600" y="10800"/>
                    </a:cubicBezTo>
                    <a:cubicBezTo>
                      <a:pt x="16200" y="10800"/>
                      <a:pt x="10800" y="11202"/>
                      <a:pt x="10800" y="11603"/>
                    </a:cubicBezTo>
                    <a:lnTo>
                      <a:pt x="10800" y="20797"/>
                    </a:lnTo>
                    <a:cubicBezTo>
                      <a:pt x="10800" y="21199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ight Brace 153"/>
              <p:cNvSpPr/>
              <p:nvPr/>
            </p:nvSpPr>
            <p:spPr>
              <a:xfrm>
                <a:off x="6978600" y="4189320"/>
                <a:ext cx="174600" cy="35532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55320"/>
                  <a:gd name="textAreaBottom" fmla="*/ 351000 h 355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36"/>
                      <a:pt x="10800" y="871"/>
                    </a:cubicBezTo>
                    <a:lnTo>
                      <a:pt x="10800" y="9929"/>
                    </a:lnTo>
                    <a:cubicBezTo>
                      <a:pt x="10800" y="10365"/>
                      <a:pt x="16200" y="10800"/>
                      <a:pt x="21600" y="10800"/>
                    </a:cubicBezTo>
                    <a:cubicBezTo>
                      <a:pt x="16200" y="10800"/>
                      <a:pt x="10800" y="11236"/>
                      <a:pt x="10800" y="11671"/>
                    </a:cubicBezTo>
                    <a:lnTo>
                      <a:pt x="10800" y="20729"/>
                    </a:lnTo>
                    <a:cubicBezTo>
                      <a:pt x="10800" y="21165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ight Brace 154"/>
              <p:cNvSpPr/>
              <p:nvPr/>
            </p:nvSpPr>
            <p:spPr>
              <a:xfrm>
                <a:off x="6977160" y="4590720"/>
                <a:ext cx="174600" cy="374400"/>
              </a:xfrm>
              <a:custGeom>
                <a:avLst/>
                <a:gdLst>
                  <a:gd name="textAreaLeft" fmla="*/ 0 w 174600"/>
                  <a:gd name="textAreaRight" fmla="*/ 63000 w 174600"/>
                  <a:gd name="textAreaTop" fmla="*/ 4320 h 374400"/>
                  <a:gd name="textAreaBottom" fmla="*/ 370080 h 3744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414"/>
                      <a:pt x="10800" y="827"/>
                    </a:cubicBezTo>
                    <a:lnTo>
                      <a:pt x="10800" y="9973"/>
                    </a:lnTo>
                    <a:cubicBezTo>
                      <a:pt x="10800" y="10387"/>
                      <a:pt x="16200" y="10800"/>
                      <a:pt x="21600" y="10800"/>
                    </a:cubicBezTo>
                    <a:cubicBezTo>
                      <a:pt x="16200" y="10800"/>
                      <a:pt x="10800" y="11214"/>
                      <a:pt x="10800" y="11627"/>
                    </a:cubicBezTo>
                    <a:lnTo>
                      <a:pt x="10800" y="20773"/>
                    </a:lnTo>
                    <a:cubicBezTo>
                      <a:pt x="10800" y="21187"/>
                      <a:pt x="5400" y="21600"/>
                      <a:pt x="0" y="21600"/>
                    </a:cubicBezTo>
                  </a:path>
                </a:pathLst>
              </a:custGeom>
              <a:noFill/>
              <a:ln w="9360">
                <a:solidFill>
                  <a:srgbClr val="c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7" name="Group 10242"/>
            <p:cNvGrpSpPr/>
            <p:nvPr/>
          </p:nvGrpSpPr>
          <p:grpSpPr>
            <a:xfrm>
              <a:off x="1394280" y="1085400"/>
              <a:ext cx="2293920" cy="1856520"/>
              <a:chOff x="1394280" y="1085400"/>
              <a:chExt cx="2293920" cy="1856520"/>
            </a:xfrm>
          </p:grpSpPr>
          <p:pic>
            <p:nvPicPr>
              <p:cNvPr id="218" name="Picture 7" descr=""/>
              <p:cNvPicPr/>
              <p:nvPr/>
            </p:nvPicPr>
            <p:blipFill>
              <a:blip r:embed="rId56"/>
              <a:stretch/>
            </p:blipFill>
            <p:spPr>
              <a:xfrm>
                <a:off x="2139480" y="1085400"/>
                <a:ext cx="1548720" cy="101772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219" name="Straight Arrow Connector 91"/>
              <p:cNvCxnSpPr/>
              <p:nvPr/>
            </p:nvCxnSpPr>
            <p:spPr>
              <a:xfrm flipV="1">
                <a:off x="1394280" y="2043000"/>
                <a:ext cx="810000" cy="89928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</p:grpSp>
        <p:grpSp>
          <p:nvGrpSpPr>
            <p:cNvPr id="220" name="Group 10240"/>
            <p:cNvGrpSpPr/>
            <p:nvPr/>
          </p:nvGrpSpPr>
          <p:grpSpPr>
            <a:xfrm>
              <a:off x="766080" y="2217240"/>
              <a:ext cx="3804840" cy="3787200"/>
              <a:chOff x="766080" y="2217240"/>
              <a:chExt cx="3804840" cy="3787200"/>
            </a:xfrm>
          </p:grpSpPr>
          <p:pic>
            <p:nvPicPr>
              <p:cNvPr id="221" name="Picture 15" descr=""/>
              <p:cNvPicPr/>
              <p:nvPr/>
            </p:nvPicPr>
            <p:blipFill>
              <a:blip r:embed="rId57"/>
              <a:stretch/>
            </p:blipFill>
            <p:spPr>
              <a:xfrm>
                <a:off x="3852360" y="3378240"/>
                <a:ext cx="640440" cy="421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2" name="Picture 2" descr=""/>
              <p:cNvPicPr/>
              <p:nvPr/>
            </p:nvPicPr>
            <p:blipFill>
              <a:blip r:embed="rId58"/>
              <a:stretch/>
            </p:blipFill>
            <p:spPr>
              <a:xfrm>
                <a:off x="3889440" y="4090320"/>
                <a:ext cx="588240" cy="386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3" name="Picture 4" descr=""/>
              <p:cNvPicPr/>
              <p:nvPr/>
            </p:nvPicPr>
            <p:blipFill>
              <a:blip r:embed="rId59"/>
              <a:stretch/>
            </p:blipFill>
            <p:spPr>
              <a:xfrm>
                <a:off x="3843360" y="2580840"/>
                <a:ext cx="661680" cy="434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4" name="Picture 1" descr=""/>
              <p:cNvPicPr/>
              <p:nvPr/>
            </p:nvPicPr>
            <p:blipFill>
              <a:blip r:embed="rId60"/>
              <a:stretch/>
            </p:blipFill>
            <p:spPr>
              <a:xfrm>
                <a:off x="3833280" y="2217240"/>
                <a:ext cx="674640" cy="443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5" name="Picture 5" descr=""/>
              <p:cNvPicPr/>
              <p:nvPr/>
            </p:nvPicPr>
            <p:blipFill>
              <a:blip r:embed="rId61"/>
              <a:stretch/>
            </p:blipFill>
            <p:spPr>
              <a:xfrm>
                <a:off x="3834720" y="2917800"/>
                <a:ext cx="661680" cy="434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6" name="Picture 17" descr=""/>
              <p:cNvPicPr/>
              <p:nvPr/>
            </p:nvPicPr>
            <p:blipFill>
              <a:blip r:embed="rId62"/>
              <a:stretch/>
            </p:blipFill>
            <p:spPr>
              <a:xfrm>
                <a:off x="3859920" y="3755520"/>
                <a:ext cx="618840" cy="407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7" name="Picture 80911" descr=""/>
              <p:cNvPicPr/>
              <p:nvPr/>
            </p:nvPicPr>
            <p:blipFill>
              <a:blip r:embed="rId63"/>
              <a:stretch/>
            </p:blipFill>
            <p:spPr>
              <a:xfrm>
                <a:off x="3852360" y="4906080"/>
                <a:ext cx="718560" cy="47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8" name="Picture 80912" descr=""/>
              <p:cNvPicPr/>
              <p:nvPr/>
            </p:nvPicPr>
            <p:blipFill>
              <a:blip r:embed="rId64"/>
              <a:stretch/>
            </p:blipFill>
            <p:spPr>
              <a:xfrm>
                <a:off x="3852360" y="5301720"/>
                <a:ext cx="712440" cy="468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9" name="Picture 80910" descr=""/>
              <p:cNvPicPr/>
              <p:nvPr/>
            </p:nvPicPr>
            <p:blipFill>
              <a:blip r:embed="rId65"/>
              <a:stretch/>
            </p:blipFill>
            <p:spPr>
              <a:xfrm>
                <a:off x="3821760" y="4507920"/>
                <a:ext cx="743040" cy="4885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230" name="Group 139"/>
              <p:cNvGrpSpPr/>
              <p:nvPr/>
            </p:nvGrpSpPr>
            <p:grpSpPr>
              <a:xfrm>
                <a:off x="3622320" y="2507760"/>
                <a:ext cx="294480" cy="653040"/>
                <a:chOff x="3622320" y="2507760"/>
                <a:chExt cx="294480" cy="653040"/>
              </a:xfrm>
            </p:grpSpPr>
            <p:cxnSp>
              <p:nvCxnSpPr>
                <p:cNvPr id="231" name="Straight Arrow Connector 87"/>
                <p:cNvCxnSpPr/>
                <p:nvPr/>
              </p:nvCxnSpPr>
              <p:spPr>
                <a:xfrm flipV="1">
                  <a:off x="3622320" y="2507760"/>
                  <a:ext cx="294840" cy="12132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32" name="Straight Arrow Connector 88"/>
                <p:cNvCxnSpPr/>
                <p:nvPr/>
              </p:nvCxnSpPr>
              <p:spPr>
                <a:xfrm>
                  <a:off x="3622320" y="3030120"/>
                  <a:ext cx="294840" cy="13104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33" name="Straight Arrow Connector 89"/>
                <p:cNvCxnSpPr/>
                <p:nvPr/>
              </p:nvCxnSpPr>
              <p:spPr>
                <a:xfrm>
                  <a:off x="3695400" y="2797560"/>
                  <a:ext cx="158040" cy="10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</p:grpSp>
          <p:grpSp>
            <p:nvGrpSpPr>
              <p:cNvPr id="234" name="Group 143"/>
              <p:cNvGrpSpPr/>
              <p:nvPr/>
            </p:nvGrpSpPr>
            <p:grpSpPr>
              <a:xfrm>
                <a:off x="3626640" y="3755880"/>
                <a:ext cx="294480" cy="652680"/>
                <a:chOff x="3626640" y="3755880"/>
                <a:chExt cx="294480" cy="652680"/>
              </a:xfrm>
            </p:grpSpPr>
            <p:cxnSp>
              <p:nvCxnSpPr>
                <p:cNvPr id="235" name="Straight Arrow Connector 84"/>
                <p:cNvCxnSpPr/>
                <p:nvPr/>
              </p:nvCxnSpPr>
              <p:spPr>
                <a:xfrm flipV="1">
                  <a:off x="3626640" y="3755880"/>
                  <a:ext cx="294840" cy="12132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36" name="Straight Arrow Connector 85"/>
                <p:cNvCxnSpPr/>
                <p:nvPr/>
              </p:nvCxnSpPr>
              <p:spPr>
                <a:xfrm>
                  <a:off x="3626640" y="4278240"/>
                  <a:ext cx="294840" cy="1306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37" name="Straight Arrow Connector 86"/>
                <p:cNvCxnSpPr/>
                <p:nvPr/>
              </p:nvCxnSpPr>
              <p:spPr>
                <a:xfrm>
                  <a:off x="3699720" y="4046400"/>
                  <a:ext cx="158040" cy="10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</p:grpSp>
          <p:grpSp>
            <p:nvGrpSpPr>
              <p:cNvPr id="238" name="Group 90152"/>
              <p:cNvGrpSpPr/>
              <p:nvPr/>
            </p:nvGrpSpPr>
            <p:grpSpPr>
              <a:xfrm>
                <a:off x="3467520" y="4853880"/>
                <a:ext cx="441000" cy="957960"/>
                <a:chOff x="3467520" y="4853880"/>
                <a:chExt cx="441000" cy="957960"/>
              </a:xfrm>
            </p:grpSpPr>
            <p:cxnSp>
              <p:nvCxnSpPr>
                <p:cNvPr id="239" name="Straight Arrow Connector 79"/>
                <p:cNvCxnSpPr/>
                <p:nvPr/>
              </p:nvCxnSpPr>
              <p:spPr>
                <a:xfrm flipV="1">
                  <a:off x="3614760" y="4853880"/>
                  <a:ext cx="294120" cy="12132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40" name="Straight Arrow Connector 80"/>
                <p:cNvCxnSpPr/>
                <p:nvPr/>
              </p:nvCxnSpPr>
              <p:spPr>
                <a:xfrm>
                  <a:off x="3614760" y="5376240"/>
                  <a:ext cx="294120" cy="1306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41" name="Straight Arrow Connector 81"/>
                <p:cNvCxnSpPr/>
                <p:nvPr/>
              </p:nvCxnSpPr>
              <p:spPr>
                <a:xfrm>
                  <a:off x="3688200" y="5142960"/>
                  <a:ext cx="157680" cy="108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42" name="Straight Arrow Connector 82"/>
                <p:cNvCxnSpPr/>
                <p:nvPr/>
              </p:nvCxnSpPr>
              <p:spPr>
                <a:xfrm>
                  <a:off x="3529080" y="5406480"/>
                  <a:ext cx="367200" cy="30672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  <p:cxnSp>
              <p:nvCxnSpPr>
                <p:cNvPr id="243" name="Straight Arrow Connector 83"/>
                <p:cNvCxnSpPr/>
                <p:nvPr/>
              </p:nvCxnSpPr>
              <p:spPr>
                <a:xfrm>
                  <a:off x="3467520" y="5430600"/>
                  <a:ext cx="259200" cy="381600"/>
                </a:xfrm>
                <a:prstGeom prst="straightConnector1">
                  <a:avLst/>
                </a:prstGeom>
                <a:ln w="9360">
                  <a:solidFill>
                    <a:srgbClr val="6b6bcf"/>
                  </a:solidFill>
                  <a:miter/>
                  <a:tailEnd len="med" type="arrow" w="med"/>
                </a:ln>
              </p:spPr>
            </p:cxnSp>
          </p:grpSp>
          <p:pic>
            <p:nvPicPr>
              <p:cNvPr id="244" name="Picture 23" descr=""/>
              <p:cNvPicPr/>
              <p:nvPr/>
            </p:nvPicPr>
            <p:blipFill>
              <a:blip r:embed="rId66"/>
              <a:stretch/>
            </p:blipFill>
            <p:spPr>
              <a:xfrm>
                <a:off x="2143440" y="2265480"/>
                <a:ext cx="1544760" cy="1014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5" name="Picture 22" descr=""/>
              <p:cNvPicPr/>
              <p:nvPr/>
            </p:nvPicPr>
            <p:blipFill>
              <a:blip r:embed="rId67"/>
              <a:stretch/>
            </p:blipFill>
            <p:spPr>
              <a:xfrm>
                <a:off x="2151000" y="3435120"/>
                <a:ext cx="1539000" cy="10101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6" name="Picture 79923" descr=""/>
              <p:cNvPicPr/>
              <p:nvPr/>
            </p:nvPicPr>
            <p:blipFill>
              <a:blip r:embed="rId68"/>
              <a:stretch/>
            </p:blipFill>
            <p:spPr>
              <a:xfrm>
                <a:off x="2143440" y="4576680"/>
                <a:ext cx="1544760" cy="101448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247" name="Straight Arrow Connector 74"/>
              <p:cNvCxnSpPr/>
              <p:nvPr/>
            </p:nvCxnSpPr>
            <p:spPr>
              <a:xfrm flipV="1">
                <a:off x="1628640" y="3022920"/>
                <a:ext cx="589680" cy="23868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  <p:cxnSp>
            <p:nvCxnSpPr>
              <p:cNvPr id="248" name="Straight Arrow Connector 75"/>
              <p:cNvCxnSpPr/>
              <p:nvPr/>
            </p:nvCxnSpPr>
            <p:spPr>
              <a:xfrm>
                <a:off x="1628640" y="3646080"/>
                <a:ext cx="589680" cy="20520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  <p:cxnSp>
            <p:nvCxnSpPr>
              <p:cNvPr id="249" name="Straight Arrow Connector 76"/>
              <p:cNvCxnSpPr/>
              <p:nvPr/>
            </p:nvCxnSpPr>
            <p:spPr>
              <a:xfrm>
                <a:off x="1407600" y="3831840"/>
                <a:ext cx="810360" cy="1148040"/>
              </a:xfrm>
              <a:prstGeom prst="straightConnector1">
                <a:avLst/>
              </a:prstGeom>
              <a:ln w="9360">
                <a:solidFill>
                  <a:srgbClr val="ff0000"/>
                </a:solidFill>
                <a:miter/>
                <a:tailEnd len="med" type="arrow" w="med"/>
              </a:ln>
            </p:spPr>
          </p:cxnSp>
          <p:pic>
            <p:nvPicPr>
              <p:cNvPr id="250" name="Picture 17" descr=""/>
              <p:cNvPicPr/>
              <p:nvPr/>
            </p:nvPicPr>
            <p:blipFill>
              <a:blip r:embed="rId69"/>
              <a:stretch/>
            </p:blipFill>
            <p:spPr>
              <a:xfrm>
                <a:off x="766080" y="4955040"/>
                <a:ext cx="1598040" cy="104940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251" name="Straight Arrow Connector 78"/>
              <p:cNvCxnSpPr/>
              <p:nvPr/>
            </p:nvCxnSpPr>
            <p:spPr>
              <a:xfrm>
                <a:off x="1187280" y="3893400"/>
                <a:ext cx="442080" cy="1173960"/>
              </a:xfrm>
              <a:prstGeom prst="straightConnector1">
                <a:avLst/>
              </a:prstGeom>
              <a:ln w="9360">
                <a:solidFill>
                  <a:srgbClr val="f33d4e"/>
                </a:solidFill>
                <a:miter/>
                <a:tailEnd len="med" type="arrow" w="med"/>
              </a:ln>
            </p:spPr>
          </p:cxnSp>
        </p:grpSp>
        <p:grpSp>
          <p:nvGrpSpPr>
            <p:cNvPr id="252" name="Group 10241"/>
            <p:cNvGrpSpPr/>
            <p:nvPr/>
          </p:nvGrpSpPr>
          <p:grpSpPr>
            <a:xfrm>
              <a:off x="3614400" y="769680"/>
              <a:ext cx="4912920" cy="1519920"/>
              <a:chOff x="3614400" y="769680"/>
              <a:chExt cx="4912920" cy="1519920"/>
            </a:xfrm>
          </p:grpSpPr>
          <p:grpSp>
            <p:nvGrpSpPr>
              <p:cNvPr id="253" name="Group 126"/>
              <p:cNvGrpSpPr/>
              <p:nvPr/>
            </p:nvGrpSpPr>
            <p:grpSpPr>
              <a:xfrm>
                <a:off x="4273560" y="769680"/>
                <a:ext cx="2350440" cy="349920"/>
                <a:chOff x="4273560" y="769680"/>
                <a:chExt cx="2350440" cy="349920"/>
              </a:xfrm>
            </p:grpSpPr>
            <p:sp>
              <p:nvSpPr>
                <p:cNvPr id="254" name="Freeform 57"/>
                <p:cNvSpPr/>
                <p:nvPr/>
              </p:nvSpPr>
              <p:spPr>
                <a:xfrm>
                  <a:off x="4352760" y="870840"/>
                  <a:ext cx="1738080" cy="248760"/>
                </a:xfrm>
                <a:custGeom>
                  <a:avLst/>
                  <a:gdLst/>
                  <a:ahLst/>
                  <a:rect l="l" t="t" r="r" b="b"/>
                  <a:pathLst>
                    <a:path w="1356479" h="261491">
                      <a:moveTo>
                        <a:pt x="0" y="261491"/>
                      </a:moveTo>
                      <a:cubicBezTo>
                        <a:pt x="400579" y="139253"/>
                        <a:pt x="801158" y="17016"/>
                        <a:pt x="1022350" y="1141"/>
                      </a:cubicBezTo>
                      <a:cubicBezTo>
                        <a:pt x="1243542" y="-14734"/>
                        <a:pt x="1276350" y="139783"/>
                        <a:pt x="1327150" y="166241"/>
                      </a:cubicBezTo>
                      <a:cubicBezTo>
                        <a:pt x="1377950" y="192699"/>
                        <a:pt x="1352550" y="176295"/>
                        <a:pt x="1327150" y="159891"/>
                      </a:cubicBez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Freeform 58"/>
                <p:cNvSpPr/>
                <p:nvPr/>
              </p:nvSpPr>
              <p:spPr>
                <a:xfrm>
                  <a:off x="4273560" y="769680"/>
                  <a:ext cx="2350440" cy="326160"/>
                </a:xfrm>
                <a:custGeom>
                  <a:avLst/>
                  <a:gdLst/>
                  <a:ahLst/>
                  <a:rect l="l" t="t" r="r" b="b"/>
                  <a:pathLst>
                    <a:path w="1847850" h="343125">
                      <a:moveTo>
                        <a:pt x="0" y="343125"/>
                      </a:moveTo>
                      <a:cubicBezTo>
                        <a:pt x="455612" y="176437"/>
                        <a:pt x="911225" y="9750"/>
                        <a:pt x="1219200" y="225"/>
                      </a:cubicBezTo>
                      <a:cubicBezTo>
                        <a:pt x="1527175" y="-9300"/>
                        <a:pt x="1847850" y="285975"/>
                        <a:pt x="1847850" y="285975"/>
                      </a:cubicBezTo>
                      <a:lnTo>
                        <a:pt x="1847850" y="285975"/>
                      </a:lnTo>
                    </a:path>
                  </a:pathLst>
                </a:custGeom>
                <a:noFill/>
                <a:ln w="9360">
                  <a:solidFill>
                    <a:srgbClr val="89a4a7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56" name="Group 99"/>
              <p:cNvGrpSpPr/>
              <p:nvPr/>
            </p:nvGrpSpPr>
            <p:grpSpPr>
              <a:xfrm>
                <a:off x="7102440" y="835920"/>
                <a:ext cx="1424880" cy="1447560"/>
                <a:chOff x="7102440" y="835920"/>
                <a:chExt cx="1424880" cy="1447560"/>
              </a:xfrm>
            </p:grpSpPr>
            <p:grpSp>
              <p:nvGrpSpPr>
                <p:cNvPr id="257" name="Group 127"/>
                <p:cNvGrpSpPr/>
                <p:nvPr/>
              </p:nvGrpSpPr>
              <p:grpSpPr>
                <a:xfrm>
                  <a:off x="7102440" y="835920"/>
                  <a:ext cx="859680" cy="395640"/>
                  <a:chOff x="7102440" y="835920"/>
                  <a:chExt cx="859680" cy="395640"/>
                </a:xfrm>
              </p:grpSpPr>
              <p:sp>
                <p:nvSpPr>
                  <p:cNvPr id="258" name="Freeform 55"/>
                  <p:cNvSpPr/>
                  <p:nvPr/>
                </p:nvSpPr>
                <p:spPr>
                  <a:xfrm>
                    <a:off x="7102440" y="865800"/>
                    <a:ext cx="329760" cy="351360"/>
                  </a:xfrm>
                  <a:custGeom>
                    <a:avLst/>
                    <a:gdLst/>
                    <a:ahLst/>
                    <a:rect l="l" t="t" r="r" b="b"/>
                    <a:pathLst>
                      <a:path w="341906" h="370313">
                        <a:moveTo>
                          <a:pt x="0" y="370313"/>
                        </a:moveTo>
                        <a:cubicBezTo>
                          <a:pt x="31143" y="205323"/>
                          <a:pt x="62286" y="40334"/>
                          <a:pt x="119270" y="4553"/>
                        </a:cubicBezTo>
                        <a:cubicBezTo>
                          <a:pt x="176254" y="-31228"/>
                          <a:pt x="341906" y="155628"/>
                          <a:pt x="341906" y="155628"/>
                        </a:cubicBezTo>
                        <a:lnTo>
                          <a:pt x="341906" y="155628"/>
                        </a:lnTo>
                      </a:path>
                    </a:pathLst>
                  </a:custGeom>
                  <a:noFill/>
                  <a:ln w="3240">
                    <a:solidFill>
                      <a:srgbClr val="00b050"/>
                    </a:solidFill>
                    <a:prstDash val="dash"/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Freeform 56"/>
                  <p:cNvSpPr/>
                  <p:nvPr/>
                </p:nvSpPr>
                <p:spPr>
                  <a:xfrm>
                    <a:off x="7130880" y="835920"/>
                    <a:ext cx="831240" cy="395640"/>
                  </a:xfrm>
                  <a:custGeom>
                    <a:avLst/>
                    <a:gdLst/>
                    <a:ahLst/>
                    <a:rect l="l" t="t" r="r" b="b"/>
                    <a:pathLst>
                      <a:path w="341906" h="370313">
                        <a:moveTo>
                          <a:pt x="0" y="370313"/>
                        </a:moveTo>
                        <a:cubicBezTo>
                          <a:pt x="31143" y="205323"/>
                          <a:pt x="62286" y="40334"/>
                          <a:pt x="119270" y="4553"/>
                        </a:cubicBezTo>
                        <a:cubicBezTo>
                          <a:pt x="176254" y="-31228"/>
                          <a:pt x="341906" y="155628"/>
                          <a:pt x="341906" y="155628"/>
                        </a:cubicBezTo>
                        <a:lnTo>
                          <a:pt x="341906" y="155628"/>
                        </a:lnTo>
                      </a:path>
                    </a:pathLst>
                  </a:custGeom>
                  <a:noFill/>
                  <a:ln w="3240">
                    <a:solidFill>
                      <a:srgbClr val="ff0000"/>
                    </a:solidFill>
                    <a:prstDash val="sysDash"/>
                    <a:round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pic>
              <p:nvPicPr>
                <p:cNvPr id="260" name="Picture 16" descr=""/>
                <p:cNvPicPr/>
                <p:nvPr/>
              </p:nvPicPr>
              <p:blipFill>
                <a:blip r:embed="rId70"/>
                <a:stretch/>
              </p:blipFill>
              <p:spPr>
                <a:xfrm>
                  <a:off x="7965000" y="1545840"/>
                  <a:ext cx="562320" cy="3697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1" name="Picture 17" descr=""/>
                <p:cNvPicPr/>
                <p:nvPr/>
              </p:nvPicPr>
              <p:blipFill>
                <a:blip r:embed="rId71"/>
                <a:stretch/>
              </p:blipFill>
              <p:spPr>
                <a:xfrm>
                  <a:off x="7969680" y="1921320"/>
                  <a:ext cx="551520" cy="362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2" name="Picture 79913" descr=""/>
                <p:cNvPicPr/>
                <p:nvPr/>
              </p:nvPicPr>
              <p:blipFill>
                <a:blip r:embed="rId72"/>
                <a:stretch/>
              </p:blipFill>
              <p:spPr>
                <a:xfrm>
                  <a:off x="7283160" y="1547280"/>
                  <a:ext cx="541800" cy="3560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3" name="Picture 79914" descr=""/>
                <p:cNvPicPr/>
                <p:nvPr/>
              </p:nvPicPr>
              <p:blipFill>
                <a:blip r:embed="rId73"/>
                <a:stretch/>
              </p:blipFill>
              <p:spPr>
                <a:xfrm>
                  <a:off x="7286040" y="1919160"/>
                  <a:ext cx="539280" cy="354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4" name="Picture 79872" descr=""/>
                <p:cNvPicPr/>
                <p:nvPr/>
              </p:nvPicPr>
              <p:blipFill>
                <a:blip r:embed="rId74"/>
                <a:stretch/>
              </p:blipFill>
              <p:spPr>
                <a:xfrm>
                  <a:off x="7290720" y="1182240"/>
                  <a:ext cx="534600" cy="349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5" name="Picture 15" descr=""/>
                <p:cNvPicPr/>
                <p:nvPr/>
              </p:nvPicPr>
              <p:blipFill>
                <a:blip r:embed="rId75"/>
                <a:stretch/>
              </p:blipFill>
              <p:spPr>
                <a:xfrm>
                  <a:off x="7965000" y="1181160"/>
                  <a:ext cx="548640" cy="3592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266" name="Group 97"/>
              <p:cNvGrpSpPr/>
              <p:nvPr/>
            </p:nvGrpSpPr>
            <p:grpSpPr>
              <a:xfrm>
                <a:off x="5741640" y="1115280"/>
                <a:ext cx="1296360" cy="1174320"/>
                <a:chOff x="5741640" y="1115280"/>
                <a:chExt cx="1296360" cy="1174320"/>
              </a:xfrm>
            </p:grpSpPr>
            <p:pic>
              <p:nvPicPr>
                <p:cNvPr id="267" name="Picture 10" descr=""/>
                <p:cNvPicPr/>
                <p:nvPr/>
              </p:nvPicPr>
              <p:blipFill>
                <a:blip r:embed="rId76"/>
                <a:stretch/>
              </p:blipFill>
              <p:spPr>
                <a:xfrm>
                  <a:off x="5741640" y="1115280"/>
                  <a:ext cx="625680" cy="412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68" name="Picture 97" descr=""/>
                <p:cNvPicPr/>
                <p:nvPr/>
              </p:nvPicPr>
              <p:blipFill>
                <a:blip r:embed="rId77"/>
                <a:stretch/>
              </p:blipFill>
              <p:spPr>
                <a:xfrm>
                  <a:off x="5751000" y="1501200"/>
                  <a:ext cx="615960" cy="4053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69" name="Straight Connector 43"/>
                <p:cNvSpPr/>
                <p:nvPr/>
              </p:nvSpPr>
              <p:spPr>
                <a:xfrm>
                  <a:off x="6559560" y="2223720"/>
                  <a:ext cx="280800" cy="0"/>
                </a:xfrm>
                <a:prstGeom prst="line">
                  <a:avLst/>
                </a:prstGeom>
                <a:ln w="9360">
                  <a:solidFill>
                    <a:srgbClr val="00b05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70" name="Picture 96" descr=""/>
                <p:cNvPicPr/>
                <p:nvPr/>
              </p:nvPicPr>
              <p:blipFill>
                <a:blip r:embed="rId78"/>
                <a:stretch/>
              </p:blipFill>
              <p:spPr>
                <a:xfrm>
                  <a:off x="5743080" y="1869840"/>
                  <a:ext cx="623160" cy="4104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71" name="Picture 101" descr=""/>
                <p:cNvPicPr/>
                <p:nvPr/>
              </p:nvPicPr>
              <p:blipFill>
                <a:blip r:embed="rId79"/>
                <a:stretch/>
              </p:blipFill>
              <p:spPr>
                <a:xfrm>
                  <a:off x="6390000" y="1133280"/>
                  <a:ext cx="644040" cy="422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72" name="Picture 102" descr=""/>
                <p:cNvPicPr/>
                <p:nvPr/>
              </p:nvPicPr>
              <p:blipFill>
                <a:blip r:embed="rId80"/>
                <a:stretch/>
              </p:blipFill>
              <p:spPr>
                <a:xfrm>
                  <a:off x="6396480" y="1504440"/>
                  <a:ext cx="641520" cy="421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73" name="Picture 103" descr=""/>
                <p:cNvPicPr/>
                <p:nvPr/>
              </p:nvPicPr>
              <p:blipFill>
                <a:blip r:embed="rId81"/>
                <a:stretch/>
              </p:blipFill>
              <p:spPr>
                <a:xfrm>
                  <a:off x="6391080" y="1869120"/>
                  <a:ext cx="641520" cy="4204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274" name="Group 98"/>
              <p:cNvGrpSpPr/>
              <p:nvPr/>
            </p:nvGrpSpPr>
            <p:grpSpPr>
              <a:xfrm>
                <a:off x="6959880" y="1137960"/>
                <a:ext cx="179280" cy="1049040"/>
                <a:chOff x="6959880" y="1137960"/>
                <a:chExt cx="179280" cy="1049040"/>
              </a:xfrm>
            </p:grpSpPr>
            <p:sp>
              <p:nvSpPr>
                <p:cNvPr id="275" name="Right Brace 38"/>
                <p:cNvSpPr/>
                <p:nvPr/>
              </p:nvSpPr>
              <p:spPr>
                <a:xfrm>
                  <a:off x="6959880" y="1137960"/>
                  <a:ext cx="177840" cy="306360"/>
                </a:xfrm>
                <a:custGeom>
                  <a:avLst/>
                  <a:gdLst>
                    <a:gd name="textAreaLeft" fmla="*/ 0 w 177840"/>
                    <a:gd name="textAreaRight" fmla="*/ 64080 w 177840"/>
                    <a:gd name="textAreaTop" fmla="*/ 4320 h 306360"/>
                    <a:gd name="textAreaBottom" fmla="*/ 302040 h 3063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4"/>
                        <a:pt x="10800" y="1027"/>
                      </a:cubicBezTo>
                      <a:lnTo>
                        <a:pt x="10800" y="9773"/>
                      </a:lnTo>
                      <a:cubicBezTo>
                        <a:pt x="10800" y="10287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4"/>
                        <a:pt x="10800" y="11827"/>
                      </a:cubicBezTo>
                      <a:lnTo>
                        <a:pt x="10800" y="20573"/>
                      </a:lnTo>
                      <a:cubicBezTo>
                        <a:pt x="10800" y="21087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ight Brace 39"/>
                <p:cNvSpPr/>
                <p:nvPr/>
              </p:nvSpPr>
              <p:spPr>
                <a:xfrm>
                  <a:off x="6961320" y="1509120"/>
                  <a:ext cx="177840" cy="307800"/>
                </a:xfrm>
                <a:custGeom>
                  <a:avLst/>
                  <a:gdLst>
                    <a:gd name="textAreaLeft" fmla="*/ 0 w 177840"/>
                    <a:gd name="textAreaRight" fmla="*/ 64080 w 177840"/>
                    <a:gd name="textAreaTop" fmla="*/ 4320 h 307800"/>
                    <a:gd name="textAreaBottom" fmla="*/ 303480 h 3078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1"/>
                        <a:pt x="10800" y="1021"/>
                      </a:cubicBezTo>
                      <a:lnTo>
                        <a:pt x="10800" y="9779"/>
                      </a:lnTo>
                      <a:cubicBezTo>
                        <a:pt x="10800" y="10290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1"/>
                        <a:pt x="10800" y="11821"/>
                      </a:cubicBezTo>
                      <a:lnTo>
                        <a:pt x="10800" y="20579"/>
                      </a:lnTo>
                      <a:cubicBezTo>
                        <a:pt x="10800" y="21090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Right Brace 40"/>
                <p:cNvSpPr/>
                <p:nvPr/>
              </p:nvSpPr>
              <p:spPr>
                <a:xfrm>
                  <a:off x="6959880" y="1880640"/>
                  <a:ext cx="177840" cy="306360"/>
                </a:xfrm>
                <a:custGeom>
                  <a:avLst/>
                  <a:gdLst>
                    <a:gd name="textAreaLeft" fmla="*/ 0 w 177840"/>
                    <a:gd name="textAreaRight" fmla="*/ 64080 w 177840"/>
                    <a:gd name="textAreaTop" fmla="*/ 4320 h 306360"/>
                    <a:gd name="textAreaBottom" fmla="*/ 302040 h 3063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5400" y="0"/>
                        <a:pt x="10800" y="514"/>
                        <a:pt x="10800" y="1027"/>
                      </a:cubicBezTo>
                      <a:lnTo>
                        <a:pt x="10800" y="9773"/>
                      </a:lnTo>
                      <a:cubicBezTo>
                        <a:pt x="10800" y="10287"/>
                        <a:pt x="16200" y="10800"/>
                        <a:pt x="21600" y="10800"/>
                      </a:cubicBezTo>
                      <a:cubicBezTo>
                        <a:pt x="16200" y="10800"/>
                        <a:pt x="10800" y="11314"/>
                        <a:pt x="10800" y="11827"/>
                      </a:cubicBezTo>
                      <a:lnTo>
                        <a:pt x="10800" y="20573"/>
                      </a:lnTo>
                      <a:cubicBezTo>
                        <a:pt x="10800" y="21087"/>
                        <a:pt x="54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78" name="Group 96"/>
              <p:cNvGrpSpPr/>
              <p:nvPr/>
            </p:nvGrpSpPr>
            <p:grpSpPr>
              <a:xfrm>
                <a:off x="4272120" y="995400"/>
                <a:ext cx="1469520" cy="1277640"/>
                <a:chOff x="4272120" y="995400"/>
                <a:chExt cx="1469520" cy="1277640"/>
              </a:xfrm>
            </p:grpSpPr>
            <p:pic>
              <p:nvPicPr>
                <p:cNvPr id="279" name="Picture 12" descr=""/>
                <p:cNvPicPr/>
                <p:nvPr/>
              </p:nvPicPr>
              <p:blipFill>
                <a:blip r:embed="rId82"/>
                <a:stretch/>
              </p:blipFill>
              <p:spPr>
                <a:xfrm>
                  <a:off x="5088600" y="1113840"/>
                  <a:ext cx="639360" cy="419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80" name="Picture 13" descr=""/>
                <p:cNvPicPr/>
                <p:nvPr/>
              </p:nvPicPr>
              <p:blipFill>
                <a:blip r:embed="rId83"/>
                <a:stretch/>
              </p:blipFill>
              <p:spPr>
                <a:xfrm>
                  <a:off x="5074920" y="1469520"/>
                  <a:ext cx="666720" cy="437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81" name="Picture 14" descr=""/>
                <p:cNvPicPr/>
                <p:nvPr/>
              </p:nvPicPr>
              <p:blipFill>
                <a:blip r:embed="rId84"/>
                <a:stretch/>
              </p:blipFill>
              <p:spPr>
                <a:xfrm>
                  <a:off x="5074920" y="1848960"/>
                  <a:ext cx="645840" cy="4240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82" name="Freeform 90147"/>
                <p:cNvSpPr/>
                <p:nvPr/>
              </p:nvSpPr>
              <p:spPr>
                <a:xfrm rot="21417600">
                  <a:off x="4307040" y="1023120"/>
                  <a:ext cx="1062000" cy="204840"/>
                </a:xfrm>
                <a:custGeom>
                  <a:avLst/>
                  <a:gdLst/>
                  <a:ahLst/>
                  <a:rect l="l" t="t" r="r" b="b"/>
                  <a:pathLst>
                    <a:path w="1205346" h="215915">
                      <a:moveTo>
                        <a:pt x="0" y="215915"/>
                      </a:moveTo>
                      <a:cubicBezTo>
                        <a:pt x="147452" y="147632"/>
                        <a:pt x="294904" y="79349"/>
                        <a:pt x="463138" y="43723"/>
                      </a:cubicBezTo>
                      <a:cubicBezTo>
                        <a:pt x="631372" y="8097"/>
                        <a:pt x="885702" y="-5758"/>
                        <a:pt x="1009403" y="2159"/>
                      </a:cubicBezTo>
                      <a:cubicBezTo>
                        <a:pt x="1133104" y="10076"/>
                        <a:pt x="1205346" y="91224"/>
                        <a:pt x="1205346" y="91224"/>
                      </a:cubicBezTo>
                      <a:lnTo>
                        <a:pt x="1205346" y="91224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Straight Connector 33"/>
                <p:cNvSpPr/>
                <p:nvPr/>
              </p:nvSpPr>
              <p:spPr>
                <a:xfrm>
                  <a:off x="4272120" y="1788480"/>
                  <a:ext cx="374400" cy="1440"/>
                </a:xfrm>
                <a:prstGeom prst="line">
                  <a:avLst/>
                </a:prstGeom>
                <a:ln w="9360">
                  <a:solidFill>
                    <a:srgbClr val="b6dcd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84" name="Picture 55" descr=""/>
                <p:cNvPicPr/>
                <p:nvPr/>
              </p:nvPicPr>
              <p:blipFill>
                <a:blip r:embed="rId85"/>
                <a:stretch/>
              </p:blipFill>
              <p:spPr>
                <a:xfrm>
                  <a:off x="4508280" y="1099800"/>
                  <a:ext cx="650880" cy="427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85" name="Picture 56" descr=""/>
                <p:cNvPicPr/>
                <p:nvPr/>
              </p:nvPicPr>
              <p:blipFill>
                <a:blip r:embed="rId86"/>
                <a:stretch/>
              </p:blipFill>
              <p:spPr>
                <a:xfrm>
                  <a:off x="4511880" y="1476360"/>
                  <a:ext cx="635400" cy="4172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86" name="Picture 57" descr=""/>
                <p:cNvPicPr/>
                <p:nvPr/>
              </p:nvPicPr>
              <p:blipFill>
                <a:blip r:embed="rId87"/>
                <a:stretch/>
              </p:blipFill>
              <p:spPr>
                <a:xfrm>
                  <a:off x="4509720" y="1847520"/>
                  <a:ext cx="644400" cy="423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87" name="Freeform 90145"/>
                <p:cNvSpPr/>
                <p:nvPr/>
              </p:nvSpPr>
              <p:spPr>
                <a:xfrm rot="21369000">
                  <a:off x="4316040" y="1126080"/>
                  <a:ext cx="399960" cy="109440"/>
                </a:xfrm>
                <a:custGeom>
                  <a:avLst/>
                  <a:gdLst/>
                  <a:ahLst/>
                  <a:rect l="l" t="t" r="r" b="b"/>
                  <a:pathLst>
                    <a:path w="540327" h="168179">
                      <a:moveTo>
                        <a:pt x="0" y="168179"/>
                      </a:moveTo>
                      <a:cubicBezTo>
                        <a:pt x="139040" y="92968"/>
                        <a:pt x="278081" y="17758"/>
                        <a:pt x="368135" y="1924"/>
                      </a:cubicBezTo>
                      <a:cubicBezTo>
                        <a:pt x="458190" y="-13910"/>
                        <a:pt x="540327" y="73176"/>
                        <a:pt x="540327" y="73176"/>
                      </a:cubicBezTo>
                      <a:lnTo>
                        <a:pt x="540327" y="73176"/>
                      </a:lnTo>
                    </a:path>
                  </a:pathLst>
                </a:custGeom>
                <a:noFill/>
                <a:ln w="6480">
                  <a:solidFill>
                    <a:srgbClr val="c00000"/>
                  </a:solidFill>
                  <a:round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88" name="Group 95"/>
              <p:cNvGrpSpPr/>
              <p:nvPr/>
            </p:nvGrpSpPr>
            <p:grpSpPr>
              <a:xfrm>
                <a:off x="3614400" y="1080360"/>
                <a:ext cx="887760" cy="1182240"/>
                <a:chOff x="3614400" y="1080360"/>
                <a:chExt cx="887760" cy="1182240"/>
              </a:xfrm>
            </p:grpSpPr>
            <p:pic>
              <p:nvPicPr>
                <p:cNvPr id="289" name="Picture 10" descr=""/>
                <p:cNvPicPr/>
                <p:nvPr/>
              </p:nvPicPr>
              <p:blipFill>
                <a:blip r:embed="rId88"/>
                <a:stretch/>
              </p:blipFill>
              <p:spPr>
                <a:xfrm>
                  <a:off x="3825000" y="1818720"/>
                  <a:ext cx="675720" cy="443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90" name="Picture 8" descr=""/>
                <p:cNvPicPr/>
                <p:nvPr/>
              </p:nvPicPr>
              <p:blipFill>
                <a:blip r:embed="rId89"/>
                <a:stretch/>
              </p:blipFill>
              <p:spPr>
                <a:xfrm>
                  <a:off x="3823920" y="1456920"/>
                  <a:ext cx="674640" cy="4435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291" name="Picture 6" descr=""/>
                <p:cNvPicPr/>
                <p:nvPr/>
              </p:nvPicPr>
              <p:blipFill>
                <a:blip r:embed="rId90"/>
                <a:stretch/>
              </p:blipFill>
              <p:spPr>
                <a:xfrm>
                  <a:off x="3822840" y="1080360"/>
                  <a:ext cx="679320" cy="4464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292" name="Group 23"/>
                <p:cNvGrpSpPr/>
                <p:nvPr/>
              </p:nvGrpSpPr>
              <p:grpSpPr>
                <a:xfrm>
                  <a:off x="3614400" y="1369440"/>
                  <a:ext cx="294480" cy="653040"/>
                  <a:chOff x="3614400" y="1369440"/>
                  <a:chExt cx="294480" cy="653040"/>
                </a:xfrm>
              </p:grpSpPr>
              <p:cxnSp>
                <p:nvCxnSpPr>
                  <p:cNvPr id="293" name="Straight Arrow Connector 26"/>
                  <p:cNvCxnSpPr/>
                  <p:nvPr/>
                </p:nvCxnSpPr>
                <p:spPr>
                  <a:xfrm flipV="1">
                    <a:off x="3614400" y="1369440"/>
                    <a:ext cx="294840" cy="12132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294" name="Straight Arrow Connector 27"/>
                  <p:cNvCxnSpPr/>
                  <p:nvPr/>
                </p:nvCxnSpPr>
                <p:spPr>
                  <a:xfrm>
                    <a:off x="3614400" y="1892160"/>
                    <a:ext cx="294840" cy="13068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295" name="Straight Arrow Connector 28"/>
                  <p:cNvCxnSpPr/>
                  <p:nvPr/>
                </p:nvCxnSpPr>
                <p:spPr>
                  <a:xfrm>
                    <a:off x="3687480" y="1658520"/>
                    <a:ext cx="158040" cy="1080"/>
                  </a:xfrm>
                  <a:prstGeom prst="straightConnector1">
                    <a:avLst/>
                  </a:prstGeom>
                  <a:ln w="9360">
                    <a:solidFill>
                      <a:srgbClr val="6b6bcf"/>
                    </a:solidFill>
                    <a:miter/>
                    <a:tailEnd len="med" type="arrow" w="med"/>
                  </a:ln>
                </p:spPr>
              </p:cxnSp>
            </p:grpSp>
          </p:grpSp>
        </p:grpSp>
        <p:sp>
          <p:nvSpPr>
            <p:cNvPr id="296" name="TextBox 7"/>
            <p:cNvSpPr/>
            <p:nvPr/>
          </p:nvSpPr>
          <p:spPr>
            <a:xfrm>
              <a:off x="378360" y="515880"/>
              <a:ext cx="397476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Unlike the classic (</a:t>
              </a:r>
              <a:r>
                <a:rPr b="0" lang="en-US" sz="2000" spc="-1" strike="noStrike">
                  <a:solidFill>
                    <a:srgbClr val="ff0000"/>
                  </a:solidFill>
                  <a:latin typeface="Arial"/>
                </a:rPr>
                <a:t>static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 and </a:t>
              </a:r>
              <a:r>
                <a:rPr b="0" lang="en-US" sz="2000" spc="-1" strike="noStrike">
                  <a:solidFill>
                    <a:srgbClr val="ff0000"/>
                  </a:solidFill>
                  <a:latin typeface="Arial"/>
                </a:rPr>
                <a:t>reductionist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) alternative, this method uses +1000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analyses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to evaluate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00000"/>
                  </a:solidFill>
                  <a:latin typeface="Arial"/>
                </a:rPr>
                <a:t>five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c00000"/>
                  </a:solidFill>
                  <a:latin typeface="Arial"/>
                </a:rPr>
                <a:t>concepts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</a:rPr>
                <a:t>: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7" name="Picture 1" descr=""/>
          <p:cNvPicPr/>
          <p:nvPr/>
        </p:nvPicPr>
        <p:blipFill>
          <a:blip r:embed="rId1"/>
          <a:stretch/>
        </p:blipFill>
        <p:spPr>
          <a:xfrm>
            <a:off x="762120" y="876240"/>
            <a:ext cx="3716280" cy="2476440"/>
          </a:xfrm>
          <a:prstGeom prst="rect">
            <a:avLst/>
          </a:prstGeom>
          <a:ln w="0">
            <a:noFill/>
          </a:ln>
        </p:spPr>
      </p:pic>
      <p:pic>
        <p:nvPicPr>
          <p:cNvPr id="298" name="Picture 2" descr=""/>
          <p:cNvPicPr/>
          <p:nvPr/>
        </p:nvPicPr>
        <p:blipFill>
          <a:blip r:embed="rId2"/>
          <a:stretch/>
        </p:blipFill>
        <p:spPr>
          <a:xfrm>
            <a:off x="838080" y="3943440"/>
            <a:ext cx="3733920" cy="2533680"/>
          </a:xfrm>
          <a:prstGeom prst="rect">
            <a:avLst/>
          </a:prstGeom>
          <a:ln w="0">
            <a:noFill/>
          </a:ln>
        </p:spPr>
      </p:pic>
      <p:pic>
        <p:nvPicPr>
          <p:cNvPr id="299" name="Picture 3" descr=""/>
          <p:cNvPicPr/>
          <p:nvPr/>
        </p:nvPicPr>
        <p:blipFill>
          <a:blip r:embed="rId3"/>
          <a:stretch/>
        </p:blipFill>
        <p:spPr>
          <a:xfrm>
            <a:off x="5029200" y="762120"/>
            <a:ext cx="3809880" cy="2539800"/>
          </a:xfrm>
          <a:prstGeom prst="rect">
            <a:avLst/>
          </a:prstGeom>
          <a:ln w="0">
            <a:noFill/>
          </a:ln>
        </p:spPr>
      </p:pic>
      <p:sp>
        <p:nvSpPr>
          <p:cNvPr id="300" name="Text Box 7"/>
          <p:cNvSpPr/>
          <p:nvPr/>
        </p:nvSpPr>
        <p:spPr>
          <a:xfrm>
            <a:off x="1143000" y="533520"/>
            <a:ext cx="10288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8"/>
          <p:cNvSpPr/>
          <p:nvPr/>
        </p:nvSpPr>
        <p:spPr>
          <a:xfrm>
            <a:off x="1219320" y="3733920"/>
            <a:ext cx="10285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 Box 9"/>
          <p:cNvSpPr/>
          <p:nvPr/>
        </p:nvSpPr>
        <p:spPr>
          <a:xfrm>
            <a:off x="5372280" y="533520"/>
            <a:ext cx="10285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Box 1"/>
          <p:cNvSpPr/>
          <p:nvPr/>
        </p:nvSpPr>
        <p:spPr>
          <a:xfrm>
            <a:off x="4572000" y="3200400"/>
            <a:ext cx="4419720" cy="351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500" spc="-1" strike="noStrike" u="sng">
                <a:solidFill>
                  <a:srgbClr val="000000"/>
                </a:solidFill>
                <a:uFillTx/>
                <a:latin typeface="Arial"/>
              </a:rPr>
              <a:t>SF 6</a:t>
            </a: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.While hantavirus-infected humans revealed numerous data patterns when the Pattern Recognition Method was applied (SF1-SF5), hematologic and demographic data did not distinguish outcomes, even when age was controlled for sex (SF6 A-C)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BC: white blood cell count (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/m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BC: red blood cell count (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/m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GB: hemoglobin (g/d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CHC: mean corpuscl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moglobin concentration (g/d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let: platelet count (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/ml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DWc: red blood cells distribution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dth concentration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MI: body mass inde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:female; M:mal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16"/>
          <p:cNvSpPr/>
          <p:nvPr/>
        </p:nvSpPr>
        <p:spPr>
          <a:xfrm>
            <a:off x="257760" y="146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F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26T19:34:14Z</dcterms:created>
  <dc:creator>Ariel Rivas</dc:creator>
  <dc:description/>
  <dc:language>en-US</dc:language>
  <cp:lastModifiedBy>HSC Employee</cp:lastModifiedBy>
  <dcterms:modified xsi:type="dcterms:W3CDTF">2019-05-01T20:32:02Z</dcterms:modified>
  <cp:revision>780</cp:revision>
  <dc:subject/>
  <dc:title>Slide 1</dc:title>
</cp:coreProperties>
</file>